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3"/>
  </p:notesMasterIdLst>
  <p:sldIdLst>
    <p:sldId id="256" r:id="rId2"/>
    <p:sldId id="261" r:id="rId3"/>
    <p:sldId id="266" r:id="rId4"/>
    <p:sldId id="268" r:id="rId5"/>
    <p:sldId id="289" r:id="rId6"/>
    <p:sldId id="290" r:id="rId7"/>
    <p:sldId id="282" r:id="rId8"/>
    <p:sldId id="280" r:id="rId9"/>
    <p:sldId id="283" r:id="rId10"/>
    <p:sldId id="286" r:id="rId11"/>
    <p:sldId id="277" r:id="rId1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6980" autoAdjust="0"/>
    <p:restoredTop sz="82321" autoAdjust="0"/>
  </p:normalViewPr>
  <p:slideViewPr>
    <p:cSldViewPr snapToGrid="0" showGuides="1">
      <p:cViewPr varScale="1">
        <p:scale>
          <a:sx n="55" d="100"/>
          <a:sy n="55" d="100"/>
        </p:scale>
        <p:origin x="1020" y="28"/>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F320140-E9EF-4820-B142-66BF9D1FF7AE}" type="datetimeFigureOut">
              <a:rPr lang="en-GB" smtClean="0"/>
              <a:t>10/05/2023</a:t>
            </a:fld>
            <a:endParaRPr lang="en-GB"/>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D927BC9-EFA8-4308-B07B-A12026043B63}" type="slidenum">
              <a:rPr lang="en-GB" smtClean="0"/>
              <a:t>‹#›</a:t>
            </a:fld>
            <a:endParaRPr lang="en-GB"/>
          </a:p>
        </p:txBody>
      </p:sp>
    </p:spTree>
    <p:extLst>
      <p:ext uri="{BB962C8B-B14F-4D97-AF65-F5344CB8AC3E}">
        <p14:creationId xmlns:p14="http://schemas.microsoft.com/office/powerpoint/2010/main" val="9397665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dirty="0"/>
              <a:t>SF1.</a:t>
            </a:r>
            <a:r>
              <a:rPr lang="en-GB" baseline="0" dirty="0"/>
              <a:t> Boxplots to indicate the median marker expression between blood (red) and tumour (green). There is h</a:t>
            </a:r>
            <a:r>
              <a:rPr lang="en-GB" dirty="0"/>
              <a:t>igher</a:t>
            </a:r>
            <a:r>
              <a:rPr lang="en-GB" baseline="0" dirty="0"/>
              <a:t> expression of CD21, CD5, CD27 and CXCR5 in the circulation. There is higher expression of CD95 PDL1 CD138 intra-tumourally.</a:t>
            </a:r>
            <a:endParaRPr lang="en-GB" dirty="0"/>
          </a:p>
          <a:p>
            <a:endParaRPr lang="en-GB" dirty="0"/>
          </a:p>
        </p:txBody>
      </p:sp>
      <p:sp>
        <p:nvSpPr>
          <p:cNvPr id="4" name="Slide Number Placeholder 3"/>
          <p:cNvSpPr>
            <a:spLocks noGrp="1"/>
          </p:cNvSpPr>
          <p:nvPr>
            <p:ph type="sldNum" sz="quarter" idx="5"/>
          </p:nvPr>
        </p:nvSpPr>
        <p:spPr/>
        <p:txBody>
          <a:bodyPr/>
          <a:lstStyle/>
          <a:p>
            <a:fld id="{0C6CCB0A-4FCD-4F47-889D-F3D53B22E844}" type="slidenum">
              <a:rPr lang="en-GB" smtClean="0"/>
              <a:t>2</a:t>
            </a:fld>
            <a:endParaRPr lang="en-GB"/>
          </a:p>
        </p:txBody>
      </p:sp>
    </p:spTree>
    <p:extLst>
      <p:ext uri="{BB962C8B-B14F-4D97-AF65-F5344CB8AC3E}">
        <p14:creationId xmlns:p14="http://schemas.microsoft.com/office/powerpoint/2010/main" val="192816520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dirty="0"/>
              <a:t>SF10. </a:t>
            </a:r>
            <a:r>
              <a:rPr lang="en-GB" sz="1800" dirty="0">
                <a:effectLst/>
                <a:latin typeface="Calibri" panose="020F0502020204030204" pitchFamily="34" charset="0"/>
                <a:ea typeface="Calibri" panose="020F0502020204030204" pitchFamily="34" charset="0"/>
                <a:cs typeface="Calibri" panose="020F0502020204030204" pitchFamily="34" charset="0"/>
              </a:rPr>
              <a:t>UMAP plots stratified according to condition, “Adenocarcinoma (LUAD)” and “Squamous Cell Carcinoma (LUSC)” in the circulation. All samples are randomly </a:t>
            </a:r>
            <a:r>
              <a:rPr lang="en-GB" sz="1800" dirty="0" err="1">
                <a:effectLst/>
                <a:latin typeface="Calibri" panose="020F0502020204030204" pitchFamily="34" charset="0"/>
                <a:ea typeface="Calibri" panose="020F0502020204030204" pitchFamily="34" charset="0"/>
                <a:cs typeface="Calibri" panose="020F0502020204030204" pitchFamily="34" charset="0"/>
              </a:rPr>
              <a:t>downsampled</a:t>
            </a:r>
            <a:r>
              <a:rPr lang="en-GB" sz="1800" dirty="0">
                <a:effectLst/>
                <a:latin typeface="Calibri" panose="020F0502020204030204" pitchFamily="34" charset="0"/>
                <a:ea typeface="Calibri" panose="020F0502020204030204" pitchFamily="34" charset="0"/>
                <a:cs typeface="Calibri" panose="020F0502020204030204" pitchFamily="34" charset="0"/>
              </a:rPr>
              <a:t> to account for equally representative populations across samples. Clusters are labelled in the right-hand chart. Comparative UMAP demonstrating higher visual circulating expression of cluster 3, 11, and 18 in LUAD as indicated by the blue boxes.</a:t>
            </a:r>
            <a:endParaRPr lang="en-GB" sz="1800" dirty="0">
              <a:effectLst/>
              <a:latin typeface="Calibri" panose="020F0502020204030204" pitchFamily="34" charset="0"/>
              <a:ea typeface="Calibri" panose="020F0502020204030204" pitchFamily="34" charset="0"/>
              <a:cs typeface="Times New Roman" panose="02020603050405020304" pitchFamily="18" charset="0"/>
            </a:endParaRPr>
          </a:p>
          <a:p>
            <a:endParaRPr lang="en-GB" dirty="0"/>
          </a:p>
        </p:txBody>
      </p:sp>
      <p:sp>
        <p:nvSpPr>
          <p:cNvPr id="4" name="Slide Number Placeholder 3"/>
          <p:cNvSpPr>
            <a:spLocks noGrp="1"/>
          </p:cNvSpPr>
          <p:nvPr>
            <p:ph type="sldNum" sz="quarter" idx="5"/>
          </p:nvPr>
        </p:nvSpPr>
        <p:spPr/>
        <p:txBody>
          <a:bodyPr/>
          <a:lstStyle/>
          <a:p>
            <a:fld id="{0C6CCB0A-4FCD-4F47-889D-F3D53B22E844}" type="slidenum">
              <a:rPr lang="en-GB" smtClean="0"/>
              <a:t>11</a:t>
            </a:fld>
            <a:endParaRPr lang="en-GB"/>
          </a:p>
        </p:txBody>
      </p:sp>
    </p:spTree>
    <p:extLst>
      <p:ext uri="{BB962C8B-B14F-4D97-AF65-F5344CB8AC3E}">
        <p14:creationId xmlns:p14="http://schemas.microsoft.com/office/powerpoint/2010/main" val="283459344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sz="1800" dirty="0">
                <a:effectLst/>
                <a:latin typeface="Calibri" panose="020F0502020204030204" pitchFamily="34" charset="0"/>
                <a:ea typeface="Calibri" panose="020F0502020204030204" pitchFamily="34" charset="0"/>
                <a:cs typeface="Times New Roman" panose="02020603050405020304" pitchFamily="18" charset="0"/>
              </a:rPr>
              <a:t>SF2. A Multi-dimensional scaling plot demonstrating compartmental differences in a public dataset based on principal component analysis.</a:t>
            </a:r>
            <a:r>
              <a:rPr lang="en-GB" dirty="0"/>
              <a:t>.</a:t>
            </a:r>
          </a:p>
        </p:txBody>
      </p:sp>
      <p:sp>
        <p:nvSpPr>
          <p:cNvPr id="4" name="Slide Number Placeholder 3"/>
          <p:cNvSpPr>
            <a:spLocks noGrp="1"/>
          </p:cNvSpPr>
          <p:nvPr>
            <p:ph type="sldNum" sz="quarter" idx="5"/>
          </p:nvPr>
        </p:nvSpPr>
        <p:spPr/>
        <p:txBody>
          <a:bodyPr/>
          <a:lstStyle/>
          <a:p>
            <a:fld id="{0C6CCB0A-4FCD-4F47-889D-F3D53B22E844}" type="slidenum">
              <a:rPr lang="en-GB" smtClean="0"/>
              <a:t>3</a:t>
            </a:fld>
            <a:endParaRPr lang="en-GB"/>
          </a:p>
        </p:txBody>
      </p:sp>
    </p:spTree>
    <p:extLst>
      <p:ext uri="{BB962C8B-B14F-4D97-AF65-F5344CB8AC3E}">
        <p14:creationId xmlns:p14="http://schemas.microsoft.com/office/powerpoint/2010/main" val="314663416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GB" dirty="0"/>
              <a:t>SF3. </a:t>
            </a:r>
            <a:r>
              <a:rPr lang="en-GB" sz="1200" dirty="0">
                <a:effectLst/>
                <a:latin typeface="Calibri" panose="020F0502020204030204" pitchFamily="34" charset="0"/>
                <a:ea typeface="Calibri" panose="020F0502020204030204" pitchFamily="34" charset="0"/>
              </a:rPr>
              <a:t>A </a:t>
            </a:r>
            <a:r>
              <a:rPr lang="en-GB" sz="1200" dirty="0" err="1">
                <a:effectLst/>
                <a:latin typeface="Calibri" panose="020F0502020204030204" pitchFamily="34" charset="0"/>
                <a:ea typeface="Calibri" panose="020F0502020204030204" pitchFamily="34" charset="0"/>
              </a:rPr>
              <a:t>heatmap</a:t>
            </a:r>
            <a:r>
              <a:rPr lang="en-GB" sz="1200" dirty="0">
                <a:effectLst/>
                <a:latin typeface="Calibri" panose="020F0502020204030204" pitchFamily="34" charset="0"/>
                <a:ea typeface="Calibri" panose="020F0502020204030204" pitchFamily="34" charset="0"/>
              </a:rPr>
              <a:t> demonstrating the predominant 20 clusters in the B cell repertoire, as seen following </a:t>
            </a:r>
            <a:r>
              <a:rPr lang="en-GB" sz="1200" dirty="0" err="1">
                <a:effectLst/>
                <a:latin typeface="Calibri" panose="020F0502020204030204" pitchFamily="34" charset="0"/>
                <a:ea typeface="Calibri" panose="020F0502020204030204" pitchFamily="34" charset="0"/>
              </a:rPr>
              <a:t>FlowSOM</a:t>
            </a:r>
            <a:r>
              <a:rPr lang="en-GB" sz="1200" dirty="0">
                <a:effectLst/>
                <a:latin typeface="Calibri" panose="020F0502020204030204" pitchFamily="34" charset="0"/>
                <a:ea typeface="Calibri" panose="020F0502020204030204" pitchFamily="34" charset="0"/>
              </a:rPr>
              <a:t> clustering in blood only. Phenotyping markers are labelled</a:t>
            </a:r>
            <a:r>
              <a:rPr lang="en-GB" sz="1200" baseline="0" dirty="0">
                <a:effectLst/>
                <a:latin typeface="Calibri" panose="020F0502020204030204" pitchFamily="34" charset="0"/>
                <a:ea typeface="Calibri" panose="020F0502020204030204" pitchFamily="34" charset="0"/>
              </a:rPr>
              <a:t> along the x-axis. Clusters are labelled along the right y axis along with proportions as percentages of the overall population. Median scaled expression is shown in the intensity chart and used to determine expression of each marker. </a:t>
            </a:r>
            <a:endParaRPr lang="en-GB" dirty="0"/>
          </a:p>
          <a:p>
            <a:endParaRPr lang="en-GB" dirty="0"/>
          </a:p>
        </p:txBody>
      </p:sp>
      <p:sp>
        <p:nvSpPr>
          <p:cNvPr id="4" name="Slide Number Placeholder 3"/>
          <p:cNvSpPr>
            <a:spLocks noGrp="1"/>
          </p:cNvSpPr>
          <p:nvPr>
            <p:ph type="sldNum" sz="quarter" idx="5"/>
          </p:nvPr>
        </p:nvSpPr>
        <p:spPr/>
        <p:txBody>
          <a:bodyPr/>
          <a:lstStyle/>
          <a:p>
            <a:fld id="{0C6CCB0A-4FCD-4F47-889D-F3D53B22E844}" type="slidenum">
              <a:rPr lang="en-GB" smtClean="0"/>
              <a:t>4</a:t>
            </a:fld>
            <a:endParaRPr lang="en-GB"/>
          </a:p>
        </p:txBody>
      </p:sp>
    </p:spTree>
    <p:extLst>
      <p:ext uri="{BB962C8B-B14F-4D97-AF65-F5344CB8AC3E}">
        <p14:creationId xmlns:p14="http://schemas.microsoft.com/office/powerpoint/2010/main" val="364006625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dirty="0"/>
              <a:t>SF4. </a:t>
            </a:r>
            <a:r>
              <a:rPr lang="en-GB" sz="1800" dirty="0">
                <a:effectLst/>
                <a:latin typeface="Calibri" panose="020F0502020204030204" pitchFamily="34" charset="0"/>
                <a:ea typeface="Calibri" panose="020F0502020204030204" pitchFamily="34" charset="0"/>
                <a:cs typeface="Calibri" panose="020F0502020204030204" pitchFamily="34" charset="0"/>
              </a:rPr>
              <a:t>Boxplot demonstrating the differences in phenotype infiltration across tumour compartments. Pairwise Wilcoxon Rank Sums Test was used to determine statistical significance. *p&lt;0.05, **p&lt;0.01, ***p&lt;0.001, ****p&lt;0.0001. </a:t>
            </a:r>
            <a:endParaRPr lang="en-GB" sz="1800" dirty="0">
              <a:effectLst/>
              <a:latin typeface="Calibri" panose="020F0502020204030204" pitchFamily="34" charset="0"/>
              <a:ea typeface="Calibri" panose="020F0502020204030204" pitchFamily="34" charset="0"/>
              <a:cs typeface="Times New Roman" panose="02020603050405020304" pitchFamily="18" charset="0"/>
            </a:endParaRPr>
          </a:p>
          <a:p>
            <a:endParaRPr lang="en-GB" dirty="0"/>
          </a:p>
        </p:txBody>
      </p:sp>
      <p:sp>
        <p:nvSpPr>
          <p:cNvPr id="4" name="Slide Number Placeholder 3"/>
          <p:cNvSpPr>
            <a:spLocks noGrp="1"/>
          </p:cNvSpPr>
          <p:nvPr>
            <p:ph type="sldNum" sz="quarter" idx="5"/>
          </p:nvPr>
        </p:nvSpPr>
        <p:spPr/>
        <p:txBody>
          <a:bodyPr/>
          <a:lstStyle/>
          <a:p>
            <a:fld id="{4D927BC9-EFA8-4308-B07B-A12026043B63}" type="slidenum">
              <a:rPr lang="en-GB" smtClean="0"/>
              <a:t>5</a:t>
            </a:fld>
            <a:endParaRPr lang="en-GB"/>
          </a:p>
        </p:txBody>
      </p:sp>
    </p:spTree>
    <p:extLst>
      <p:ext uri="{BB962C8B-B14F-4D97-AF65-F5344CB8AC3E}">
        <p14:creationId xmlns:p14="http://schemas.microsoft.com/office/powerpoint/2010/main" val="199217145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dirty="0"/>
              <a:t>SF5. </a:t>
            </a:r>
            <a:r>
              <a:rPr lang="en-GB" sz="1800" dirty="0">
                <a:effectLst/>
                <a:latin typeface="Calibri" panose="020F0502020204030204" pitchFamily="34" charset="0"/>
                <a:ea typeface="Calibri" panose="020F0502020204030204" pitchFamily="34" charset="0"/>
                <a:cs typeface="Calibri" panose="020F0502020204030204" pitchFamily="34" charset="0"/>
              </a:rPr>
              <a:t>Non-small cell lung cancer tissue slices illustrating B cell geospatial distribution. The left-hand panel shows the populations lighting up as yellow, are IL-10 producing cells which are CD20+. They aggregate to the peripheral stroma of the tumour. The right-hand panel similarly shows yellow populations which represent CD138+ IL10+ cells collecting around the tumour nest in the stroma. </a:t>
            </a:r>
            <a:endParaRPr lang="en-GB" sz="1800" dirty="0">
              <a:effectLst/>
              <a:latin typeface="Calibri" panose="020F0502020204030204" pitchFamily="34" charset="0"/>
              <a:ea typeface="Calibri" panose="020F0502020204030204" pitchFamily="34" charset="0"/>
              <a:cs typeface="Times New Roman" panose="02020603050405020304" pitchFamily="18" charset="0"/>
            </a:endParaRPr>
          </a:p>
          <a:p>
            <a:endParaRPr lang="en-GB" dirty="0"/>
          </a:p>
        </p:txBody>
      </p:sp>
      <p:sp>
        <p:nvSpPr>
          <p:cNvPr id="4" name="Slide Number Placeholder 3"/>
          <p:cNvSpPr>
            <a:spLocks noGrp="1"/>
          </p:cNvSpPr>
          <p:nvPr>
            <p:ph type="sldNum" sz="quarter" idx="5"/>
          </p:nvPr>
        </p:nvSpPr>
        <p:spPr/>
        <p:txBody>
          <a:bodyPr/>
          <a:lstStyle/>
          <a:p>
            <a:fld id="{4D927BC9-EFA8-4308-B07B-A12026043B63}" type="slidenum">
              <a:rPr lang="en-GB" smtClean="0"/>
              <a:t>6</a:t>
            </a:fld>
            <a:endParaRPr lang="en-GB"/>
          </a:p>
        </p:txBody>
      </p:sp>
    </p:spTree>
    <p:extLst>
      <p:ext uri="{BB962C8B-B14F-4D97-AF65-F5344CB8AC3E}">
        <p14:creationId xmlns:p14="http://schemas.microsoft.com/office/powerpoint/2010/main" val="397115447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dirty="0"/>
              <a:t>SF6. </a:t>
            </a:r>
            <a:r>
              <a:rPr lang="en-GB" sz="1800" dirty="0">
                <a:effectLst/>
                <a:latin typeface="Calibri" panose="020F0502020204030204" pitchFamily="34" charset="0"/>
                <a:ea typeface="Calibri" panose="020F0502020204030204" pitchFamily="34" charset="0"/>
                <a:cs typeface="Calibri" panose="020F0502020204030204" pitchFamily="34" charset="0"/>
              </a:rPr>
              <a:t>UMAP plots stratified according to condition, “Ever smoker (left) and never smoker (right)” in the circulation. All samples are randomly </a:t>
            </a:r>
            <a:r>
              <a:rPr lang="en-GB" sz="1800" dirty="0" err="1">
                <a:effectLst/>
                <a:latin typeface="Calibri" panose="020F0502020204030204" pitchFamily="34" charset="0"/>
                <a:ea typeface="Calibri" panose="020F0502020204030204" pitchFamily="34" charset="0"/>
                <a:cs typeface="Calibri" panose="020F0502020204030204" pitchFamily="34" charset="0"/>
              </a:rPr>
              <a:t>downsampled</a:t>
            </a:r>
            <a:r>
              <a:rPr lang="en-GB" sz="1800" dirty="0">
                <a:effectLst/>
                <a:latin typeface="Calibri" panose="020F0502020204030204" pitchFamily="34" charset="0"/>
                <a:ea typeface="Calibri" panose="020F0502020204030204" pitchFamily="34" charset="0"/>
                <a:cs typeface="Calibri" panose="020F0502020204030204" pitchFamily="34" charset="0"/>
              </a:rPr>
              <a:t> to account for equally representative populations across samples. Clusters are labelled in the right-hand chart. Comparative UMAP demonstrating higher visual circulating expression of clusters 3, 10, 11, 16, 17 and 20 in ever smokers (left) as indicated by the blue boxes and higher visual circulating expression of clusters 1 and 18 never smokers (right) as indicated by the green boxes. Clusters 10, 11, 18 and 20 are difficult to discern visually owing to their rarity. Cluster 1 is a large follicular population, the area highlighted by the green box indicates the most striking area of gain in never smokers. </a:t>
            </a:r>
            <a:endParaRPr lang="en-GB" sz="1800" dirty="0">
              <a:effectLst/>
              <a:latin typeface="Calibri" panose="020F0502020204030204" pitchFamily="34" charset="0"/>
              <a:ea typeface="Calibri" panose="020F0502020204030204" pitchFamily="34" charset="0"/>
              <a:cs typeface="Times New Roman" panose="02020603050405020304" pitchFamily="18" charset="0"/>
            </a:endParaRPr>
          </a:p>
          <a:p>
            <a:endParaRPr lang="en-GB" dirty="0"/>
          </a:p>
        </p:txBody>
      </p:sp>
      <p:sp>
        <p:nvSpPr>
          <p:cNvPr id="4" name="Slide Number Placeholder 3"/>
          <p:cNvSpPr>
            <a:spLocks noGrp="1"/>
          </p:cNvSpPr>
          <p:nvPr>
            <p:ph type="sldNum" sz="quarter" idx="5"/>
          </p:nvPr>
        </p:nvSpPr>
        <p:spPr/>
        <p:txBody>
          <a:bodyPr/>
          <a:lstStyle/>
          <a:p>
            <a:fld id="{0C6CCB0A-4FCD-4F47-889D-F3D53B22E844}" type="slidenum">
              <a:rPr lang="en-GB" smtClean="0"/>
              <a:t>7</a:t>
            </a:fld>
            <a:endParaRPr lang="en-GB"/>
          </a:p>
        </p:txBody>
      </p:sp>
    </p:spTree>
    <p:extLst>
      <p:ext uri="{BB962C8B-B14F-4D97-AF65-F5344CB8AC3E}">
        <p14:creationId xmlns:p14="http://schemas.microsoft.com/office/powerpoint/2010/main" val="343805753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dirty="0"/>
              <a:t>SF7. </a:t>
            </a:r>
            <a:r>
              <a:rPr lang="en-GB" sz="1800" dirty="0">
                <a:effectLst/>
                <a:latin typeface="Calibri" panose="020F0502020204030204" pitchFamily="34" charset="0"/>
                <a:ea typeface="Calibri" panose="020F0502020204030204" pitchFamily="34" charset="0"/>
                <a:cs typeface="Calibri" panose="020F0502020204030204" pitchFamily="34" charset="0"/>
              </a:rPr>
              <a:t>Multi-dimensional scaling plot, Principal Component Analysis shows separation of CD19+ smoker and never-smoker populations in the blood. Ever smokers are illustrated in red and never smokers in green as indicated by the colour chart in the right-hand column.</a:t>
            </a:r>
            <a:endParaRPr lang="en-GB" sz="1800" dirty="0">
              <a:effectLst/>
              <a:latin typeface="Calibri" panose="020F0502020204030204" pitchFamily="34" charset="0"/>
              <a:ea typeface="Calibri" panose="020F0502020204030204" pitchFamily="34" charset="0"/>
              <a:cs typeface="Times New Roman" panose="02020603050405020304" pitchFamily="18" charset="0"/>
            </a:endParaRPr>
          </a:p>
          <a:p>
            <a:endParaRPr lang="en-GB" dirty="0"/>
          </a:p>
        </p:txBody>
      </p:sp>
      <p:sp>
        <p:nvSpPr>
          <p:cNvPr id="4" name="Slide Number Placeholder 3"/>
          <p:cNvSpPr>
            <a:spLocks noGrp="1"/>
          </p:cNvSpPr>
          <p:nvPr>
            <p:ph type="sldNum" sz="quarter" idx="5"/>
          </p:nvPr>
        </p:nvSpPr>
        <p:spPr/>
        <p:txBody>
          <a:bodyPr/>
          <a:lstStyle/>
          <a:p>
            <a:fld id="{0C6CCB0A-4FCD-4F47-889D-F3D53B22E844}" type="slidenum">
              <a:rPr lang="en-GB" smtClean="0"/>
              <a:t>8</a:t>
            </a:fld>
            <a:endParaRPr lang="en-GB"/>
          </a:p>
        </p:txBody>
      </p:sp>
    </p:spTree>
    <p:extLst>
      <p:ext uri="{BB962C8B-B14F-4D97-AF65-F5344CB8AC3E}">
        <p14:creationId xmlns:p14="http://schemas.microsoft.com/office/powerpoint/2010/main" val="307652378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dirty="0"/>
              <a:t>SF8. </a:t>
            </a:r>
            <a:r>
              <a:rPr lang="en-GB" sz="1800" dirty="0">
                <a:effectLst/>
                <a:latin typeface="Calibri" panose="020F0502020204030204" pitchFamily="34" charset="0"/>
                <a:ea typeface="Calibri" panose="020F0502020204030204" pitchFamily="34" charset="0"/>
                <a:cs typeface="Calibri" panose="020F0502020204030204" pitchFamily="34" charset="0"/>
              </a:rPr>
              <a:t>Scaled median marker expression box plots illustrates phenotyping marker expression stratified to ever and never smokers across all cells in the population. Ever smokers are illustrated in red and never smokers in green as indicated by the colour chart in the right-hand column. Elevated CD138, IgG and IL-10 seen in ever smokers whereas higher levels of CD38 and CXCR5 seen in never smokers.</a:t>
            </a:r>
            <a:endParaRPr lang="en-GB" sz="1800" dirty="0">
              <a:effectLst/>
              <a:latin typeface="Calibri" panose="020F0502020204030204" pitchFamily="34" charset="0"/>
              <a:ea typeface="Calibri" panose="020F0502020204030204" pitchFamily="34" charset="0"/>
              <a:cs typeface="Times New Roman" panose="02020603050405020304" pitchFamily="18" charset="0"/>
            </a:endParaRPr>
          </a:p>
          <a:p>
            <a:endParaRPr lang="en-GB" dirty="0"/>
          </a:p>
        </p:txBody>
      </p:sp>
      <p:sp>
        <p:nvSpPr>
          <p:cNvPr id="4" name="Slide Number Placeholder 3"/>
          <p:cNvSpPr>
            <a:spLocks noGrp="1"/>
          </p:cNvSpPr>
          <p:nvPr>
            <p:ph type="sldNum" sz="quarter" idx="5"/>
          </p:nvPr>
        </p:nvSpPr>
        <p:spPr/>
        <p:txBody>
          <a:bodyPr/>
          <a:lstStyle/>
          <a:p>
            <a:fld id="{0C6CCB0A-4FCD-4F47-889D-F3D53B22E844}" type="slidenum">
              <a:rPr lang="en-GB" smtClean="0"/>
              <a:t>9</a:t>
            </a:fld>
            <a:endParaRPr lang="en-GB"/>
          </a:p>
        </p:txBody>
      </p:sp>
    </p:spTree>
    <p:extLst>
      <p:ext uri="{BB962C8B-B14F-4D97-AF65-F5344CB8AC3E}">
        <p14:creationId xmlns:p14="http://schemas.microsoft.com/office/powerpoint/2010/main" val="378004476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just">
              <a:lnSpc>
                <a:spcPct val="107000"/>
              </a:lnSpc>
              <a:spcAft>
                <a:spcPts val="800"/>
              </a:spcAft>
              <a:buFont typeface="+mj-lt"/>
              <a:buNone/>
            </a:pPr>
            <a:r>
              <a:rPr lang="en-GB" sz="1800" dirty="0">
                <a:effectLst/>
                <a:latin typeface="Calibri" panose="020F0502020204030204" pitchFamily="34" charset="0"/>
                <a:ea typeface="Calibri" panose="020F0502020204030204" pitchFamily="34" charset="0"/>
                <a:cs typeface="Calibri" panose="020F0502020204030204" pitchFamily="34" charset="0"/>
              </a:rPr>
              <a:t>SF9. UMAP plots stratified according to condition, “Ever smoker (left) and never smoker (right)” in the TME. All samples are randomly </a:t>
            </a:r>
            <a:r>
              <a:rPr lang="en-GB" sz="1800" dirty="0" err="1">
                <a:effectLst/>
                <a:latin typeface="Calibri" panose="020F0502020204030204" pitchFamily="34" charset="0"/>
                <a:ea typeface="Calibri" panose="020F0502020204030204" pitchFamily="34" charset="0"/>
                <a:cs typeface="Calibri" panose="020F0502020204030204" pitchFamily="34" charset="0"/>
              </a:rPr>
              <a:t>downsampled</a:t>
            </a:r>
            <a:r>
              <a:rPr lang="en-GB" sz="1800" dirty="0">
                <a:effectLst/>
                <a:latin typeface="Calibri" panose="020F0502020204030204" pitchFamily="34" charset="0"/>
                <a:ea typeface="Calibri" panose="020F0502020204030204" pitchFamily="34" charset="0"/>
                <a:cs typeface="Calibri" panose="020F0502020204030204" pitchFamily="34" charset="0"/>
              </a:rPr>
              <a:t> to account for equally representative populations across samples. Clusters are labelled in the right-hand chart. Comparative UMAP demonstrating higher visual circulating expression of clusters 3, 11, 13, 14 and 15 in ever smokers (left) as indicated by the blue boxes and higher visual circulating expression of clusters 5 and 8 never smokers (right) as indicated by the green boxes. </a:t>
            </a:r>
            <a:endParaRPr lang="en-GB" sz="18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4" name="Slide Number Placeholder 3"/>
          <p:cNvSpPr>
            <a:spLocks noGrp="1"/>
          </p:cNvSpPr>
          <p:nvPr>
            <p:ph type="sldNum" sz="quarter" idx="5"/>
          </p:nvPr>
        </p:nvSpPr>
        <p:spPr/>
        <p:txBody>
          <a:bodyPr/>
          <a:lstStyle/>
          <a:p>
            <a:fld id="{0C6CCB0A-4FCD-4F47-889D-F3D53B22E844}" type="slidenum">
              <a:rPr lang="en-GB" smtClean="0"/>
              <a:t>10</a:t>
            </a:fld>
            <a:endParaRPr lang="en-GB"/>
          </a:p>
        </p:txBody>
      </p:sp>
    </p:spTree>
    <p:extLst>
      <p:ext uri="{BB962C8B-B14F-4D97-AF65-F5344CB8AC3E}">
        <p14:creationId xmlns:p14="http://schemas.microsoft.com/office/powerpoint/2010/main" val="139398764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41369B2-6DBA-480E-9E94-33A2E3CB828B}"/>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a:extLst>
              <a:ext uri="{FF2B5EF4-FFF2-40B4-BE49-F238E27FC236}">
                <a16:creationId xmlns:a16="http://schemas.microsoft.com/office/drawing/2014/main" id="{2B7146A9-FAF2-4107-BC4C-87155C28C91B}"/>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a:extLst>
              <a:ext uri="{FF2B5EF4-FFF2-40B4-BE49-F238E27FC236}">
                <a16:creationId xmlns:a16="http://schemas.microsoft.com/office/drawing/2014/main" id="{2EC36562-2E25-4F89-A070-65BE136E13F2}"/>
              </a:ext>
            </a:extLst>
          </p:cNvPr>
          <p:cNvSpPr>
            <a:spLocks noGrp="1"/>
          </p:cNvSpPr>
          <p:nvPr>
            <p:ph type="dt" sz="half" idx="10"/>
          </p:nvPr>
        </p:nvSpPr>
        <p:spPr/>
        <p:txBody>
          <a:bodyPr/>
          <a:lstStyle/>
          <a:p>
            <a:fld id="{6D85FE83-6073-4D7B-B14B-1B1AFC2A084F}" type="datetimeFigureOut">
              <a:rPr lang="en-GB" smtClean="0"/>
              <a:t>10/05/2023</a:t>
            </a:fld>
            <a:endParaRPr lang="en-GB"/>
          </a:p>
        </p:txBody>
      </p:sp>
      <p:sp>
        <p:nvSpPr>
          <p:cNvPr id="5" name="Footer Placeholder 4">
            <a:extLst>
              <a:ext uri="{FF2B5EF4-FFF2-40B4-BE49-F238E27FC236}">
                <a16:creationId xmlns:a16="http://schemas.microsoft.com/office/drawing/2014/main" id="{952B9921-40AA-4EC4-B0CA-B0B722031E18}"/>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BB7CE4B3-1D1D-4B85-AD40-971397AF3F0D}"/>
              </a:ext>
            </a:extLst>
          </p:cNvPr>
          <p:cNvSpPr>
            <a:spLocks noGrp="1"/>
          </p:cNvSpPr>
          <p:nvPr>
            <p:ph type="sldNum" sz="quarter" idx="12"/>
          </p:nvPr>
        </p:nvSpPr>
        <p:spPr/>
        <p:txBody>
          <a:bodyPr/>
          <a:lstStyle/>
          <a:p>
            <a:fld id="{F41A19D9-CE7C-4509-9275-886A62DB6999}" type="slidenum">
              <a:rPr lang="en-GB" smtClean="0"/>
              <a:t>‹#›</a:t>
            </a:fld>
            <a:endParaRPr lang="en-GB"/>
          </a:p>
        </p:txBody>
      </p:sp>
    </p:spTree>
    <p:extLst>
      <p:ext uri="{BB962C8B-B14F-4D97-AF65-F5344CB8AC3E}">
        <p14:creationId xmlns:p14="http://schemas.microsoft.com/office/powerpoint/2010/main" val="72042773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DC2C090-E745-47E3-809E-F92C8E5F0159}"/>
              </a:ext>
            </a:extLst>
          </p:cNvPr>
          <p:cNvSpPr>
            <a:spLocks noGrp="1"/>
          </p:cNvSpPr>
          <p:nvPr>
            <p:ph type="title"/>
          </p:nvPr>
        </p:nvSpPr>
        <p:spPr/>
        <p:txBody>
          <a:bodyPr/>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907F1621-971F-420A-A613-056DE32875CA}"/>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DD443E14-0438-461E-BB92-D3F9AD60C509}"/>
              </a:ext>
            </a:extLst>
          </p:cNvPr>
          <p:cNvSpPr>
            <a:spLocks noGrp="1"/>
          </p:cNvSpPr>
          <p:nvPr>
            <p:ph type="dt" sz="half" idx="10"/>
          </p:nvPr>
        </p:nvSpPr>
        <p:spPr/>
        <p:txBody>
          <a:bodyPr/>
          <a:lstStyle/>
          <a:p>
            <a:fld id="{6D85FE83-6073-4D7B-B14B-1B1AFC2A084F}" type="datetimeFigureOut">
              <a:rPr lang="en-GB" smtClean="0"/>
              <a:t>10/05/2023</a:t>
            </a:fld>
            <a:endParaRPr lang="en-GB"/>
          </a:p>
        </p:txBody>
      </p:sp>
      <p:sp>
        <p:nvSpPr>
          <p:cNvPr id="5" name="Footer Placeholder 4">
            <a:extLst>
              <a:ext uri="{FF2B5EF4-FFF2-40B4-BE49-F238E27FC236}">
                <a16:creationId xmlns:a16="http://schemas.microsoft.com/office/drawing/2014/main" id="{9B67DC9E-F9B4-47BA-9363-3133CDF69DD2}"/>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164AB792-0187-498B-8663-E74E46C03A21}"/>
              </a:ext>
            </a:extLst>
          </p:cNvPr>
          <p:cNvSpPr>
            <a:spLocks noGrp="1"/>
          </p:cNvSpPr>
          <p:nvPr>
            <p:ph type="sldNum" sz="quarter" idx="12"/>
          </p:nvPr>
        </p:nvSpPr>
        <p:spPr/>
        <p:txBody>
          <a:bodyPr/>
          <a:lstStyle/>
          <a:p>
            <a:fld id="{F41A19D9-CE7C-4509-9275-886A62DB6999}" type="slidenum">
              <a:rPr lang="en-GB" smtClean="0"/>
              <a:t>‹#›</a:t>
            </a:fld>
            <a:endParaRPr lang="en-GB"/>
          </a:p>
        </p:txBody>
      </p:sp>
    </p:spTree>
    <p:extLst>
      <p:ext uri="{BB962C8B-B14F-4D97-AF65-F5344CB8AC3E}">
        <p14:creationId xmlns:p14="http://schemas.microsoft.com/office/powerpoint/2010/main" val="200746365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991F8A1D-E930-47DE-9D3F-3D01FB4F1A57}"/>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2D1CB137-13D7-43D3-B959-4351B760BFDE}"/>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F3932B1F-577B-4087-A638-267D0D7AB477}"/>
              </a:ext>
            </a:extLst>
          </p:cNvPr>
          <p:cNvSpPr>
            <a:spLocks noGrp="1"/>
          </p:cNvSpPr>
          <p:nvPr>
            <p:ph type="dt" sz="half" idx="10"/>
          </p:nvPr>
        </p:nvSpPr>
        <p:spPr/>
        <p:txBody>
          <a:bodyPr/>
          <a:lstStyle/>
          <a:p>
            <a:fld id="{6D85FE83-6073-4D7B-B14B-1B1AFC2A084F}" type="datetimeFigureOut">
              <a:rPr lang="en-GB" smtClean="0"/>
              <a:t>10/05/2023</a:t>
            </a:fld>
            <a:endParaRPr lang="en-GB"/>
          </a:p>
        </p:txBody>
      </p:sp>
      <p:sp>
        <p:nvSpPr>
          <p:cNvPr id="5" name="Footer Placeholder 4">
            <a:extLst>
              <a:ext uri="{FF2B5EF4-FFF2-40B4-BE49-F238E27FC236}">
                <a16:creationId xmlns:a16="http://schemas.microsoft.com/office/drawing/2014/main" id="{12A57B73-3E27-40D5-A1FA-20227292D966}"/>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E96D6D63-1A87-48F6-A3C0-433BE628AFE8}"/>
              </a:ext>
            </a:extLst>
          </p:cNvPr>
          <p:cNvSpPr>
            <a:spLocks noGrp="1"/>
          </p:cNvSpPr>
          <p:nvPr>
            <p:ph type="sldNum" sz="quarter" idx="12"/>
          </p:nvPr>
        </p:nvSpPr>
        <p:spPr/>
        <p:txBody>
          <a:bodyPr/>
          <a:lstStyle/>
          <a:p>
            <a:fld id="{F41A19D9-CE7C-4509-9275-886A62DB6999}" type="slidenum">
              <a:rPr lang="en-GB" smtClean="0"/>
              <a:t>‹#›</a:t>
            </a:fld>
            <a:endParaRPr lang="en-GB"/>
          </a:p>
        </p:txBody>
      </p:sp>
    </p:spTree>
    <p:extLst>
      <p:ext uri="{BB962C8B-B14F-4D97-AF65-F5344CB8AC3E}">
        <p14:creationId xmlns:p14="http://schemas.microsoft.com/office/powerpoint/2010/main" val="203553606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599290-E0C1-4EF4-97BD-A758376F2691}"/>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52F494EB-06B8-4448-A6FF-64F380ADC8DE}"/>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5509522E-C26D-4436-8773-DA0B326057A6}"/>
              </a:ext>
            </a:extLst>
          </p:cNvPr>
          <p:cNvSpPr>
            <a:spLocks noGrp="1"/>
          </p:cNvSpPr>
          <p:nvPr>
            <p:ph type="dt" sz="half" idx="10"/>
          </p:nvPr>
        </p:nvSpPr>
        <p:spPr/>
        <p:txBody>
          <a:bodyPr/>
          <a:lstStyle/>
          <a:p>
            <a:fld id="{6D85FE83-6073-4D7B-B14B-1B1AFC2A084F}" type="datetimeFigureOut">
              <a:rPr lang="en-GB" smtClean="0"/>
              <a:t>10/05/2023</a:t>
            </a:fld>
            <a:endParaRPr lang="en-GB"/>
          </a:p>
        </p:txBody>
      </p:sp>
      <p:sp>
        <p:nvSpPr>
          <p:cNvPr id="5" name="Footer Placeholder 4">
            <a:extLst>
              <a:ext uri="{FF2B5EF4-FFF2-40B4-BE49-F238E27FC236}">
                <a16:creationId xmlns:a16="http://schemas.microsoft.com/office/drawing/2014/main" id="{1DB38FFD-DC1E-43FD-B184-D9B24174F0C5}"/>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5A3D5FDB-D3AC-49DE-A8D2-446AA964B71D}"/>
              </a:ext>
            </a:extLst>
          </p:cNvPr>
          <p:cNvSpPr>
            <a:spLocks noGrp="1"/>
          </p:cNvSpPr>
          <p:nvPr>
            <p:ph type="sldNum" sz="quarter" idx="12"/>
          </p:nvPr>
        </p:nvSpPr>
        <p:spPr/>
        <p:txBody>
          <a:bodyPr/>
          <a:lstStyle/>
          <a:p>
            <a:fld id="{F41A19D9-CE7C-4509-9275-886A62DB6999}" type="slidenum">
              <a:rPr lang="en-GB" smtClean="0"/>
              <a:t>‹#›</a:t>
            </a:fld>
            <a:endParaRPr lang="en-GB"/>
          </a:p>
        </p:txBody>
      </p:sp>
    </p:spTree>
    <p:extLst>
      <p:ext uri="{BB962C8B-B14F-4D97-AF65-F5344CB8AC3E}">
        <p14:creationId xmlns:p14="http://schemas.microsoft.com/office/powerpoint/2010/main" val="409243224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495847B-703E-4795-AE0F-D1BF08654CEC}"/>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a:extLst>
              <a:ext uri="{FF2B5EF4-FFF2-40B4-BE49-F238E27FC236}">
                <a16:creationId xmlns:a16="http://schemas.microsoft.com/office/drawing/2014/main" id="{26330566-3FDC-454F-A8D4-0CAD3270D088}"/>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C380F5B9-1F01-4C57-AD7E-5243FD039198}"/>
              </a:ext>
            </a:extLst>
          </p:cNvPr>
          <p:cNvSpPr>
            <a:spLocks noGrp="1"/>
          </p:cNvSpPr>
          <p:nvPr>
            <p:ph type="dt" sz="half" idx="10"/>
          </p:nvPr>
        </p:nvSpPr>
        <p:spPr/>
        <p:txBody>
          <a:bodyPr/>
          <a:lstStyle/>
          <a:p>
            <a:fld id="{6D85FE83-6073-4D7B-B14B-1B1AFC2A084F}" type="datetimeFigureOut">
              <a:rPr lang="en-GB" smtClean="0"/>
              <a:t>10/05/2023</a:t>
            </a:fld>
            <a:endParaRPr lang="en-GB"/>
          </a:p>
        </p:txBody>
      </p:sp>
      <p:sp>
        <p:nvSpPr>
          <p:cNvPr id="5" name="Footer Placeholder 4">
            <a:extLst>
              <a:ext uri="{FF2B5EF4-FFF2-40B4-BE49-F238E27FC236}">
                <a16:creationId xmlns:a16="http://schemas.microsoft.com/office/drawing/2014/main" id="{1EC26D95-68F6-455B-9093-90AFE36BE058}"/>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64A658EC-31CD-4814-B31C-102F8F280B63}"/>
              </a:ext>
            </a:extLst>
          </p:cNvPr>
          <p:cNvSpPr>
            <a:spLocks noGrp="1"/>
          </p:cNvSpPr>
          <p:nvPr>
            <p:ph type="sldNum" sz="quarter" idx="12"/>
          </p:nvPr>
        </p:nvSpPr>
        <p:spPr/>
        <p:txBody>
          <a:bodyPr/>
          <a:lstStyle/>
          <a:p>
            <a:fld id="{F41A19D9-CE7C-4509-9275-886A62DB6999}" type="slidenum">
              <a:rPr lang="en-GB" smtClean="0"/>
              <a:t>‹#›</a:t>
            </a:fld>
            <a:endParaRPr lang="en-GB"/>
          </a:p>
        </p:txBody>
      </p:sp>
    </p:spTree>
    <p:extLst>
      <p:ext uri="{BB962C8B-B14F-4D97-AF65-F5344CB8AC3E}">
        <p14:creationId xmlns:p14="http://schemas.microsoft.com/office/powerpoint/2010/main" val="365712923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9604992-6E9D-4D08-B97C-9E6BB5622A0D}"/>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BC73C255-2B51-4A13-AEF8-874D84C0CF84}"/>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a:extLst>
              <a:ext uri="{FF2B5EF4-FFF2-40B4-BE49-F238E27FC236}">
                <a16:creationId xmlns:a16="http://schemas.microsoft.com/office/drawing/2014/main" id="{531EC585-8742-46A2-AC7F-12F5E40BCEF3}"/>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a:extLst>
              <a:ext uri="{FF2B5EF4-FFF2-40B4-BE49-F238E27FC236}">
                <a16:creationId xmlns:a16="http://schemas.microsoft.com/office/drawing/2014/main" id="{7DA5336A-BB9F-4AFB-86C1-2866E9A587D5}"/>
              </a:ext>
            </a:extLst>
          </p:cNvPr>
          <p:cNvSpPr>
            <a:spLocks noGrp="1"/>
          </p:cNvSpPr>
          <p:nvPr>
            <p:ph type="dt" sz="half" idx="10"/>
          </p:nvPr>
        </p:nvSpPr>
        <p:spPr/>
        <p:txBody>
          <a:bodyPr/>
          <a:lstStyle/>
          <a:p>
            <a:fld id="{6D85FE83-6073-4D7B-B14B-1B1AFC2A084F}" type="datetimeFigureOut">
              <a:rPr lang="en-GB" smtClean="0"/>
              <a:t>10/05/2023</a:t>
            </a:fld>
            <a:endParaRPr lang="en-GB"/>
          </a:p>
        </p:txBody>
      </p:sp>
      <p:sp>
        <p:nvSpPr>
          <p:cNvPr id="6" name="Footer Placeholder 5">
            <a:extLst>
              <a:ext uri="{FF2B5EF4-FFF2-40B4-BE49-F238E27FC236}">
                <a16:creationId xmlns:a16="http://schemas.microsoft.com/office/drawing/2014/main" id="{92E4149F-7B32-4AB5-B62E-AC7C2CB40980}"/>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6BF56456-B45E-4E0E-805B-D4D281DF3C11}"/>
              </a:ext>
            </a:extLst>
          </p:cNvPr>
          <p:cNvSpPr>
            <a:spLocks noGrp="1"/>
          </p:cNvSpPr>
          <p:nvPr>
            <p:ph type="sldNum" sz="quarter" idx="12"/>
          </p:nvPr>
        </p:nvSpPr>
        <p:spPr/>
        <p:txBody>
          <a:bodyPr/>
          <a:lstStyle/>
          <a:p>
            <a:fld id="{F41A19D9-CE7C-4509-9275-886A62DB6999}" type="slidenum">
              <a:rPr lang="en-GB" smtClean="0"/>
              <a:t>‹#›</a:t>
            </a:fld>
            <a:endParaRPr lang="en-GB"/>
          </a:p>
        </p:txBody>
      </p:sp>
    </p:spTree>
    <p:extLst>
      <p:ext uri="{BB962C8B-B14F-4D97-AF65-F5344CB8AC3E}">
        <p14:creationId xmlns:p14="http://schemas.microsoft.com/office/powerpoint/2010/main" val="239108030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C4BF536-E6C8-4388-92A3-79E53A6749B3}"/>
              </a:ext>
            </a:extLst>
          </p:cNvPr>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a:extLst>
              <a:ext uri="{FF2B5EF4-FFF2-40B4-BE49-F238E27FC236}">
                <a16:creationId xmlns:a16="http://schemas.microsoft.com/office/drawing/2014/main" id="{DB15EEDB-F18C-47D8-A209-C15119B98451}"/>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FEF445D4-8A34-46C7-A98F-3A8F2347BC5D}"/>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a:extLst>
              <a:ext uri="{FF2B5EF4-FFF2-40B4-BE49-F238E27FC236}">
                <a16:creationId xmlns:a16="http://schemas.microsoft.com/office/drawing/2014/main" id="{843B7F95-7086-474F-B8B4-71D7CDD7E725}"/>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62C3E1D1-D905-4EDF-A51B-C3BB3487C67D}"/>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a:extLst>
              <a:ext uri="{FF2B5EF4-FFF2-40B4-BE49-F238E27FC236}">
                <a16:creationId xmlns:a16="http://schemas.microsoft.com/office/drawing/2014/main" id="{A65CF082-AA47-4862-B236-B8EF6E63FF98}"/>
              </a:ext>
            </a:extLst>
          </p:cNvPr>
          <p:cNvSpPr>
            <a:spLocks noGrp="1"/>
          </p:cNvSpPr>
          <p:nvPr>
            <p:ph type="dt" sz="half" idx="10"/>
          </p:nvPr>
        </p:nvSpPr>
        <p:spPr/>
        <p:txBody>
          <a:bodyPr/>
          <a:lstStyle/>
          <a:p>
            <a:fld id="{6D85FE83-6073-4D7B-B14B-1B1AFC2A084F}" type="datetimeFigureOut">
              <a:rPr lang="en-GB" smtClean="0"/>
              <a:t>10/05/2023</a:t>
            </a:fld>
            <a:endParaRPr lang="en-GB"/>
          </a:p>
        </p:txBody>
      </p:sp>
      <p:sp>
        <p:nvSpPr>
          <p:cNvPr id="8" name="Footer Placeholder 7">
            <a:extLst>
              <a:ext uri="{FF2B5EF4-FFF2-40B4-BE49-F238E27FC236}">
                <a16:creationId xmlns:a16="http://schemas.microsoft.com/office/drawing/2014/main" id="{31DC01E4-62D3-42B5-B608-DADB88569FAE}"/>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2C9F7BAB-6680-493E-9B69-5D043EBF50CA}"/>
              </a:ext>
            </a:extLst>
          </p:cNvPr>
          <p:cNvSpPr>
            <a:spLocks noGrp="1"/>
          </p:cNvSpPr>
          <p:nvPr>
            <p:ph type="sldNum" sz="quarter" idx="12"/>
          </p:nvPr>
        </p:nvSpPr>
        <p:spPr/>
        <p:txBody>
          <a:bodyPr/>
          <a:lstStyle/>
          <a:p>
            <a:fld id="{F41A19D9-CE7C-4509-9275-886A62DB6999}" type="slidenum">
              <a:rPr lang="en-GB" smtClean="0"/>
              <a:t>‹#›</a:t>
            </a:fld>
            <a:endParaRPr lang="en-GB"/>
          </a:p>
        </p:txBody>
      </p:sp>
    </p:spTree>
    <p:extLst>
      <p:ext uri="{BB962C8B-B14F-4D97-AF65-F5344CB8AC3E}">
        <p14:creationId xmlns:p14="http://schemas.microsoft.com/office/powerpoint/2010/main" val="173683711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5877405-6D35-47AD-9FCC-29B747379242}"/>
              </a:ext>
            </a:extLst>
          </p:cNvPr>
          <p:cNvSpPr>
            <a:spLocks noGrp="1"/>
          </p:cNvSpPr>
          <p:nvPr>
            <p:ph type="title"/>
          </p:nvPr>
        </p:nvSpPr>
        <p:spPr/>
        <p:txBody>
          <a:bodyPr/>
          <a:lstStyle/>
          <a:p>
            <a:r>
              <a:rPr lang="en-US"/>
              <a:t>Click to edit Master title style</a:t>
            </a:r>
            <a:endParaRPr lang="en-GB"/>
          </a:p>
        </p:txBody>
      </p:sp>
      <p:sp>
        <p:nvSpPr>
          <p:cNvPr id="3" name="Date Placeholder 2">
            <a:extLst>
              <a:ext uri="{FF2B5EF4-FFF2-40B4-BE49-F238E27FC236}">
                <a16:creationId xmlns:a16="http://schemas.microsoft.com/office/drawing/2014/main" id="{8C0215FA-3898-4C9D-8C8E-8329239A83BE}"/>
              </a:ext>
            </a:extLst>
          </p:cNvPr>
          <p:cNvSpPr>
            <a:spLocks noGrp="1"/>
          </p:cNvSpPr>
          <p:nvPr>
            <p:ph type="dt" sz="half" idx="10"/>
          </p:nvPr>
        </p:nvSpPr>
        <p:spPr/>
        <p:txBody>
          <a:bodyPr/>
          <a:lstStyle/>
          <a:p>
            <a:fld id="{6D85FE83-6073-4D7B-B14B-1B1AFC2A084F}" type="datetimeFigureOut">
              <a:rPr lang="en-GB" smtClean="0"/>
              <a:t>10/05/2023</a:t>
            </a:fld>
            <a:endParaRPr lang="en-GB"/>
          </a:p>
        </p:txBody>
      </p:sp>
      <p:sp>
        <p:nvSpPr>
          <p:cNvPr id="4" name="Footer Placeholder 3">
            <a:extLst>
              <a:ext uri="{FF2B5EF4-FFF2-40B4-BE49-F238E27FC236}">
                <a16:creationId xmlns:a16="http://schemas.microsoft.com/office/drawing/2014/main" id="{1940DC0F-A649-4860-B0FB-CFF459553F5A}"/>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59E125D9-DF57-4492-AC40-24FF91FB4FDD}"/>
              </a:ext>
            </a:extLst>
          </p:cNvPr>
          <p:cNvSpPr>
            <a:spLocks noGrp="1"/>
          </p:cNvSpPr>
          <p:nvPr>
            <p:ph type="sldNum" sz="quarter" idx="12"/>
          </p:nvPr>
        </p:nvSpPr>
        <p:spPr/>
        <p:txBody>
          <a:bodyPr/>
          <a:lstStyle/>
          <a:p>
            <a:fld id="{F41A19D9-CE7C-4509-9275-886A62DB6999}" type="slidenum">
              <a:rPr lang="en-GB" smtClean="0"/>
              <a:t>‹#›</a:t>
            </a:fld>
            <a:endParaRPr lang="en-GB"/>
          </a:p>
        </p:txBody>
      </p:sp>
    </p:spTree>
    <p:extLst>
      <p:ext uri="{BB962C8B-B14F-4D97-AF65-F5344CB8AC3E}">
        <p14:creationId xmlns:p14="http://schemas.microsoft.com/office/powerpoint/2010/main" val="414391906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6A12214C-2337-4997-BA6C-D46BFF5E5DA9}"/>
              </a:ext>
            </a:extLst>
          </p:cNvPr>
          <p:cNvSpPr>
            <a:spLocks noGrp="1"/>
          </p:cNvSpPr>
          <p:nvPr>
            <p:ph type="dt" sz="half" idx="10"/>
          </p:nvPr>
        </p:nvSpPr>
        <p:spPr/>
        <p:txBody>
          <a:bodyPr/>
          <a:lstStyle/>
          <a:p>
            <a:fld id="{6D85FE83-6073-4D7B-B14B-1B1AFC2A084F}" type="datetimeFigureOut">
              <a:rPr lang="en-GB" smtClean="0"/>
              <a:t>10/05/2023</a:t>
            </a:fld>
            <a:endParaRPr lang="en-GB"/>
          </a:p>
        </p:txBody>
      </p:sp>
      <p:sp>
        <p:nvSpPr>
          <p:cNvPr id="3" name="Footer Placeholder 2">
            <a:extLst>
              <a:ext uri="{FF2B5EF4-FFF2-40B4-BE49-F238E27FC236}">
                <a16:creationId xmlns:a16="http://schemas.microsoft.com/office/drawing/2014/main" id="{8D5DBA18-81BB-4482-AEAB-BAE26F966940}"/>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2DFE6224-FC8E-4A99-8579-E3026AC32D3E}"/>
              </a:ext>
            </a:extLst>
          </p:cNvPr>
          <p:cNvSpPr>
            <a:spLocks noGrp="1"/>
          </p:cNvSpPr>
          <p:nvPr>
            <p:ph type="sldNum" sz="quarter" idx="12"/>
          </p:nvPr>
        </p:nvSpPr>
        <p:spPr/>
        <p:txBody>
          <a:bodyPr/>
          <a:lstStyle/>
          <a:p>
            <a:fld id="{F41A19D9-CE7C-4509-9275-886A62DB6999}" type="slidenum">
              <a:rPr lang="en-GB" smtClean="0"/>
              <a:t>‹#›</a:t>
            </a:fld>
            <a:endParaRPr lang="en-GB"/>
          </a:p>
        </p:txBody>
      </p:sp>
    </p:spTree>
    <p:extLst>
      <p:ext uri="{BB962C8B-B14F-4D97-AF65-F5344CB8AC3E}">
        <p14:creationId xmlns:p14="http://schemas.microsoft.com/office/powerpoint/2010/main" val="211803920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578AD4A-E887-4345-B6BD-AB841A27B16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a:extLst>
              <a:ext uri="{FF2B5EF4-FFF2-40B4-BE49-F238E27FC236}">
                <a16:creationId xmlns:a16="http://schemas.microsoft.com/office/drawing/2014/main" id="{5F743679-314A-4D43-B4B1-F9291140E844}"/>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a:extLst>
              <a:ext uri="{FF2B5EF4-FFF2-40B4-BE49-F238E27FC236}">
                <a16:creationId xmlns:a16="http://schemas.microsoft.com/office/drawing/2014/main" id="{17D44CF3-8772-421A-A6E2-583FA3BAF05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CAE8110-C1A3-4587-8175-7BC8EFD9A4E7}"/>
              </a:ext>
            </a:extLst>
          </p:cNvPr>
          <p:cNvSpPr>
            <a:spLocks noGrp="1"/>
          </p:cNvSpPr>
          <p:nvPr>
            <p:ph type="dt" sz="half" idx="10"/>
          </p:nvPr>
        </p:nvSpPr>
        <p:spPr/>
        <p:txBody>
          <a:bodyPr/>
          <a:lstStyle/>
          <a:p>
            <a:fld id="{6D85FE83-6073-4D7B-B14B-1B1AFC2A084F}" type="datetimeFigureOut">
              <a:rPr lang="en-GB" smtClean="0"/>
              <a:t>10/05/2023</a:t>
            </a:fld>
            <a:endParaRPr lang="en-GB"/>
          </a:p>
        </p:txBody>
      </p:sp>
      <p:sp>
        <p:nvSpPr>
          <p:cNvPr id="6" name="Footer Placeholder 5">
            <a:extLst>
              <a:ext uri="{FF2B5EF4-FFF2-40B4-BE49-F238E27FC236}">
                <a16:creationId xmlns:a16="http://schemas.microsoft.com/office/drawing/2014/main" id="{0AD64A07-9FFF-4B0C-93F8-DC067CB0E045}"/>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EDFD758C-15F7-4428-8D77-4DD1D914010C}"/>
              </a:ext>
            </a:extLst>
          </p:cNvPr>
          <p:cNvSpPr>
            <a:spLocks noGrp="1"/>
          </p:cNvSpPr>
          <p:nvPr>
            <p:ph type="sldNum" sz="quarter" idx="12"/>
          </p:nvPr>
        </p:nvSpPr>
        <p:spPr/>
        <p:txBody>
          <a:bodyPr/>
          <a:lstStyle/>
          <a:p>
            <a:fld id="{F41A19D9-CE7C-4509-9275-886A62DB6999}" type="slidenum">
              <a:rPr lang="en-GB" smtClean="0"/>
              <a:t>‹#›</a:t>
            </a:fld>
            <a:endParaRPr lang="en-GB"/>
          </a:p>
        </p:txBody>
      </p:sp>
    </p:spTree>
    <p:extLst>
      <p:ext uri="{BB962C8B-B14F-4D97-AF65-F5344CB8AC3E}">
        <p14:creationId xmlns:p14="http://schemas.microsoft.com/office/powerpoint/2010/main" val="69567917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3E7D6EE-CC00-4ACD-A6DB-769EA6CF875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a:extLst>
              <a:ext uri="{FF2B5EF4-FFF2-40B4-BE49-F238E27FC236}">
                <a16:creationId xmlns:a16="http://schemas.microsoft.com/office/drawing/2014/main" id="{98941D42-3AC6-4A38-B1F8-77471C9CA30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a:extLst>
              <a:ext uri="{FF2B5EF4-FFF2-40B4-BE49-F238E27FC236}">
                <a16:creationId xmlns:a16="http://schemas.microsoft.com/office/drawing/2014/main" id="{54488757-07D0-41D4-AA9E-7BA6507E207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B3BE76D-4672-4EB7-9263-1C0CB71D820C}"/>
              </a:ext>
            </a:extLst>
          </p:cNvPr>
          <p:cNvSpPr>
            <a:spLocks noGrp="1"/>
          </p:cNvSpPr>
          <p:nvPr>
            <p:ph type="dt" sz="half" idx="10"/>
          </p:nvPr>
        </p:nvSpPr>
        <p:spPr/>
        <p:txBody>
          <a:bodyPr/>
          <a:lstStyle/>
          <a:p>
            <a:fld id="{6D85FE83-6073-4D7B-B14B-1B1AFC2A084F}" type="datetimeFigureOut">
              <a:rPr lang="en-GB" smtClean="0"/>
              <a:t>10/05/2023</a:t>
            </a:fld>
            <a:endParaRPr lang="en-GB"/>
          </a:p>
        </p:txBody>
      </p:sp>
      <p:sp>
        <p:nvSpPr>
          <p:cNvPr id="6" name="Footer Placeholder 5">
            <a:extLst>
              <a:ext uri="{FF2B5EF4-FFF2-40B4-BE49-F238E27FC236}">
                <a16:creationId xmlns:a16="http://schemas.microsoft.com/office/drawing/2014/main" id="{B9366964-EDF7-4877-8E51-806AA03C4C08}"/>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21C49804-5FB7-43A2-A517-1F0C09E3D130}"/>
              </a:ext>
            </a:extLst>
          </p:cNvPr>
          <p:cNvSpPr>
            <a:spLocks noGrp="1"/>
          </p:cNvSpPr>
          <p:nvPr>
            <p:ph type="sldNum" sz="quarter" idx="12"/>
          </p:nvPr>
        </p:nvSpPr>
        <p:spPr/>
        <p:txBody>
          <a:bodyPr/>
          <a:lstStyle/>
          <a:p>
            <a:fld id="{F41A19D9-CE7C-4509-9275-886A62DB6999}" type="slidenum">
              <a:rPr lang="en-GB" smtClean="0"/>
              <a:t>‹#›</a:t>
            </a:fld>
            <a:endParaRPr lang="en-GB"/>
          </a:p>
        </p:txBody>
      </p:sp>
    </p:spTree>
    <p:extLst>
      <p:ext uri="{BB962C8B-B14F-4D97-AF65-F5344CB8AC3E}">
        <p14:creationId xmlns:p14="http://schemas.microsoft.com/office/powerpoint/2010/main" val="164923967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C0BC722D-792E-42AC-8FE7-EB58218ABEF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a:extLst>
              <a:ext uri="{FF2B5EF4-FFF2-40B4-BE49-F238E27FC236}">
                <a16:creationId xmlns:a16="http://schemas.microsoft.com/office/drawing/2014/main" id="{FFBD617B-A36A-4424-96F8-0312618B7F2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E0A3249D-28B0-485E-BBF6-AAC279E0B88E}"/>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D85FE83-6073-4D7B-B14B-1B1AFC2A084F}" type="datetimeFigureOut">
              <a:rPr lang="en-GB" smtClean="0"/>
              <a:t>10/05/2023</a:t>
            </a:fld>
            <a:endParaRPr lang="en-GB"/>
          </a:p>
        </p:txBody>
      </p:sp>
      <p:sp>
        <p:nvSpPr>
          <p:cNvPr id="5" name="Footer Placeholder 4">
            <a:extLst>
              <a:ext uri="{FF2B5EF4-FFF2-40B4-BE49-F238E27FC236}">
                <a16:creationId xmlns:a16="http://schemas.microsoft.com/office/drawing/2014/main" id="{CB07738A-23AC-4501-AFF0-773CFEC6A0AD}"/>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a:extLst>
              <a:ext uri="{FF2B5EF4-FFF2-40B4-BE49-F238E27FC236}">
                <a16:creationId xmlns:a16="http://schemas.microsoft.com/office/drawing/2014/main" id="{06A41EBF-521C-4E91-A2A7-3B4EFAF9C3D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41A19D9-CE7C-4509-9275-886A62DB6999}" type="slidenum">
              <a:rPr lang="en-GB" smtClean="0"/>
              <a:t>‹#›</a:t>
            </a:fld>
            <a:endParaRPr lang="en-GB"/>
          </a:p>
        </p:txBody>
      </p:sp>
    </p:spTree>
    <p:extLst>
      <p:ext uri="{BB962C8B-B14F-4D97-AF65-F5344CB8AC3E}">
        <p14:creationId xmlns:p14="http://schemas.microsoft.com/office/powerpoint/2010/main" val="271369592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F6B5023-4493-4904-B564-3F79474CEF92}"/>
              </a:ext>
            </a:extLst>
          </p:cNvPr>
          <p:cNvSpPr>
            <a:spLocks noGrp="1"/>
          </p:cNvSpPr>
          <p:nvPr>
            <p:ph type="ctrTitle"/>
          </p:nvPr>
        </p:nvSpPr>
        <p:spPr/>
        <p:txBody>
          <a:bodyPr/>
          <a:lstStyle/>
          <a:p>
            <a:r>
              <a:rPr lang="en-GB" dirty="0"/>
              <a:t>Supplementary Figures</a:t>
            </a:r>
          </a:p>
        </p:txBody>
      </p:sp>
      <p:sp>
        <p:nvSpPr>
          <p:cNvPr id="3" name="Subtitle 2">
            <a:extLst>
              <a:ext uri="{FF2B5EF4-FFF2-40B4-BE49-F238E27FC236}">
                <a16:creationId xmlns:a16="http://schemas.microsoft.com/office/drawing/2014/main" id="{E68BEA0D-EF42-4431-B9F0-67F3279ACE5A}"/>
              </a:ext>
            </a:extLst>
          </p:cNvPr>
          <p:cNvSpPr>
            <a:spLocks noGrp="1"/>
          </p:cNvSpPr>
          <p:nvPr>
            <p:ph type="subTitle" idx="1"/>
          </p:nvPr>
        </p:nvSpPr>
        <p:spPr/>
        <p:txBody>
          <a:bodyPr/>
          <a:lstStyle/>
          <a:p>
            <a:endParaRPr lang="en-GB"/>
          </a:p>
        </p:txBody>
      </p:sp>
    </p:spTree>
    <p:extLst>
      <p:ext uri="{BB962C8B-B14F-4D97-AF65-F5344CB8AC3E}">
        <p14:creationId xmlns:p14="http://schemas.microsoft.com/office/powerpoint/2010/main" val="224615062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C990745-FAB2-4C69-B481-85E3601D5040}"/>
              </a:ext>
            </a:extLst>
          </p:cNvPr>
          <p:cNvSpPr>
            <a:spLocks noGrp="1"/>
          </p:cNvSpPr>
          <p:nvPr>
            <p:ph type="title"/>
          </p:nvPr>
        </p:nvSpPr>
        <p:spPr/>
        <p:txBody>
          <a:bodyPr/>
          <a:lstStyle/>
          <a:p>
            <a:r>
              <a:rPr lang="en-GB" dirty="0"/>
              <a:t>Supp Fig 9.</a:t>
            </a:r>
          </a:p>
        </p:txBody>
      </p:sp>
      <p:pic>
        <p:nvPicPr>
          <p:cNvPr id="5" name="Picture 4">
            <a:extLst>
              <a:ext uri="{FF2B5EF4-FFF2-40B4-BE49-F238E27FC236}">
                <a16:creationId xmlns:a16="http://schemas.microsoft.com/office/drawing/2014/main" id="{39020A74-E7E8-4D3A-93AA-70613D98133B}"/>
              </a:ext>
            </a:extLst>
          </p:cNvPr>
          <p:cNvPicPr>
            <a:picLocks noChangeAspect="1"/>
          </p:cNvPicPr>
          <p:nvPr/>
        </p:nvPicPr>
        <p:blipFill>
          <a:blip r:embed="rId3"/>
          <a:stretch>
            <a:fillRect/>
          </a:stretch>
        </p:blipFill>
        <p:spPr>
          <a:xfrm>
            <a:off x="1039528" y="1390261"/>
            <a:ext cx="11152472" cy="5593790"/>
          </a:xfrm>
          <a:prstGeom prst="rect">
            <a:avLst/>
          </a:prstGeom>
        </p:spPr>
      </p:pic>
      <p:sp>
        <p:nvSpPr>
          <p:cNvPr id="6" name="Rectangle: Rounded Corners 5">
            <a:extLst>
              <a:ext uri="{FF2B5EF4-FFF2-40B4-BE49-F238E27FC236}">
                <a16:creationId xmlns:a16="http://schemas.microsoft.com/office/drawing/2014/main" id="{7E4C4344-514B-4118-B953-B298D0940648}"/>
              </a:ext>
            </a:extLst>
          </p:cNvPr>
          <p:cNvSpPr/>
          <p:nvPr/>
        </p:nvSpPr>
        <p:spPr>
          <a:xfrm>
            <a:off x="6783356" y="5094515"/>
            <a:ext cx="279918" cy="242596"/>
          </a:xfrm>
          <a:prstGeom prst="roundRect">
            <a:avLst/>
          </a:prstGeom>
          <a:noFill/>
          <a:ln w="28575">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7" name="Rectangle: Rounded Corners 6">
            <a:extLst>
              <a:ext uri="{FF2B5EF4-FFF2-40B4-BE49-F238E27FC236}">
                <a16:creationId xmlns:a16="http://schemas.microsoft.com/office/drawing/2014/main" id="{3F422612-054E-4D18-98CF-E88EAE60C6D8}"/>
              </a:ext>
            </a:extLst>
          </p:cNvPr>
          <p:cNvSpPr/>
          <p:nvPr/>
        </p:nvSpPr>
        <p:spPr>
          <a:xfrm>
            <a:off x="7766181" y="5918718"/>
            <a:ext cx="360782" cy="323461"/>
          </a:xfrm>
          <a:prstGeom prst="roundRect">
            <a:avLst/>
          </a:prstGeom>
          <a:noFill/>
          <a:ln w="28575">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9" name="Rectangle: Rounded Corners 8">
            <a:extLst>
              <a:ext uri="{FF2B5EF4-FFF2-40B4-BE49-F238E27FC236}">
                <a16:creationId xmlns:a16="http://schemas.microsoft.com/office/drawing/2014/main" id="{7359F05D-6710-49C2-B524-C8D3B437C4D5}"/>
              </a:ext>
            </a:extLst>
          </p:cNvPr>
          <p:cNvSpPr/>
          <p:nvPr/>
        </p:nvSpPr>
        <p:spPr>
          <a:xfrm>
            <a:off x="1514668" y="2214464"/>
            <a:ext cx="827315" cy="1461797"/>
          </a:xfrm>
          <a:prstGeom prst="roundRect">
            <a:avLst/>
          </a:prstGeom>
          <a:noFill/>
          <a:ln w="28575">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0" name="Rectangle: Rounded Corners 9">
            <a:extLst>
              <a:ext uri="{FF2B5EF4-FFF2-40B4-BE49-F238E27FC236}">
                <a16:creationId xmlns:a16="http://schemas.microsoft.com/office/drawing/2014/main" id="{41F6B2E3-7CF0-45A5-877E-4B3F9CCFF44E}"/>
              </a:ext>
            </a:extLst>
          </p:cNvPr>
          <p:cNvSpPr/>
          <p:nvPr/>
        </p:nvSpPr>
        <p:spPr>
          <a:xfrm>
            <a:off x="4923453" y="4904792"/>
            <a:ext cx="827315" cy="562948"/>
          </a:xfrm>
          <a:prstGeom prst="roundRect">
            <a:avLst/>
          </a:prstGeom>
          <a:noFill/>
          <a:ln w="28575">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1" name="Rectangle: Rounded Corners 10">
            <a:extLst>
              <a:ext uri="{FF2B5EF4-FFF2-40B4-BE49-F238E27FC236}">
                <a16:creationId xmlns:a16="http://schemas.microsoft.com/office/drawing/2014/main" id="{3DF01461-55BF-474F-B22B-4BE0DA519BB6}"/>
              </a:ext>
            </a:extLst>
          </p:cNvPr>
          <p:cNvSpPr/>
          <p:nvPr/>
        </p:nvSpPr>
        <p:spPr>
          <a:xfrm>
            <a:off x="3816220" y="1932990"/>
            <a:ext cx="1107233" cy="782834"/>
          </a:xfrm>
          <a:prstGeom prst="roundRect">
            <a:avLst/>
          </a:prstGeom>
          <a:noFill/>
          <a:ln w="28575">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Tree>
    <p:extLst>
      <p:ext uri="{BB962C8B-B14F-4D97-AF65-F5344CB8AC3E}">
        <p14:creationId xmlns:p14="http://schemas.microsoft.com/office/powerpoint/2010/main" val="404928706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B2D755-5A53-485E-8B87-B1B6601A004B}"/>
              </a:ext>
            </a:extLst>
          </p:cNvPr>
          <p:cNvSpPr>
            <a:spLocks noGrp="1"/>
          </p:cNvSpPr>
          <p:nvPr>
            <p:ph type="title"/>
          </p:nvPr>
        </p:nvSpPr>
        <p:spPr/>
        <p:txBody>
          <a:bodyPr/>
          <a:lstStyle/>
          <a:p>
            <a:r>
              <a:rPr lang="en-GB" dirty="0"/>
              <a:t>Supp Fig 10.</a:t>
            </a:r>
          </a:p>
        </p:txBody>
      </p:sp>
      <p:pic>
        <p:nvPicPr>
          <p:cNvPr id="4" name="Content Placeholder 3">
            <a:extLst>
              <a:ext uri="{FF2B5EF4-FFF2-40B4-BE49-F238E27FC236}">
                <a16:creationId xmlns:a16="http://schemas.microsoft.com/office/drawing/2014/main" id="{F774A113-179B-4E94-82AE-4D8EF23CE1CB}"/>
              </a:ext>
            </a:extLst>
          </p:cNvPr>
          <p:cNvPicPr>
            <a:picLocks noGrp="1" noChangeAspect="1"/>
          </p:cNvPicPr>
          <p:nvPr>
            <p:ph idx="1"/>
          </p:nvPr>
        </p:nvPicPr>
        <p:blipFill>
          <a:blip r:embed="rId3"/>
          <a:stretch>
            <a:fillRect/>
          </a:stretch>
        </p:blipFill>
        <p:spPr>
          <a:xfrm>
            <a:off x="981777" y="1409298"/>
            <a:ext cx="9981398" cy="5123265"/>
          </a:xfrm>
          <a:prstGeom prst="rect">
            <a:avLst/>
          </a:prstGeom>
        </p:spPr>
      </p:pic>
      <p:sp>
        <p:nvSpPr>
          <p:cNvPr id="6" name="Rectangle: Rounded Corners 5">
            <a:extLst>
              <a:ext uri="{FF2B5EF4-FFF2-40B4-BE49-F238E27FC236}">
                <a16:creationId xmlns:a16="http://schemas.microsoft.com/office/drawing/2014/main" id="{1F956A1E-C1BF-4394-88AD-B62758B9BDD1}"/>
              </a:ext>
            </a:extLst>
          </p:cNvPr>
          <p:cNvSpPr/>
          <p:nvPr/>
        </p:nvSpPr>
        <p:spPr>
          <a:xfrm>
            <a:off x="2175309" y="1992429"/>
            <a:ext cx="269508" cy="240631"/>
          </a:xfrm>
          <a:prstGeom prst="roundRect">
            <a:avLst/>
          </a:prstGeom>
          <a:noFill/>
          <a:ln w="28575">
            <a:solidFill>
              <a:schemeClr val="accent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 name="Rectangle: Rounded Corners 6">
            <a:extLst>
              <a:ext uri="{FF2B5EF4-FFF2-40B4-BE49-F238E27FC236}">
                <a16:creationId xmlns:a16="http://schemas.microsoft.com/office/drawing/2014/main" id="{0E2265B6-9B74-4E2F-BE2E-1249BF95E458}"/>
              </a:ext>
            </a:extLst>
          </p:cNvPr>
          <p:cNvSpPr/>
          <p:nvPr/>
        </p:nvSpPr>
        <p:spPr>
          <a:xfrm>
            <a:off x="2585988" y="4302576"/>
            <a:ext cx="263090" cy="312020"/>
          </a:xfrm>
          <a:prstGeom prst="roundRect">
            <a:avLst/>
          </a:prstGeom>
          <a:noFill/>
          <a:ln w="28575">
            <a:solidFill>
              <a:schemeClr val="accent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8" name="Rectangle: Rounded Corners 7">
            <a:extLst>
              <a:ext uri="{FF2B5EF4-FFF2-40B4-BE49-F238E27FC236}">
                <a16:creationId xmlns:a16="http://schemas.microsoft.com/office/drawing/2014/main" id="{BBADD9D0-153F-4731-BFD7-6966E063C4D4}"/>
              </a:ext>
            </a:extLst>
          </p:cNvPr>
          <p:cNvSpPr/>
          <p:nvPr/>
        </p:nvSpPr>
        <p:spPr>
          <a:xfrm>
            <a:off x="2585988" y="5136682"/>
            <a:ext cx="330467" cy="312020"/>
          </a:xfrm>
          <a:prstGeom prst="roundRect">
            <a:avLst/>
          </a:prstGeom>
          <a:noFill/>
          <a:ln w="28575">
            <a:solidFill>
              <a:schemeClr val="accent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Tree>
    <p:extLst>
      <p:ext uri="{BB962C8B-B14F-4D97-AF65-F5344CB8AC3E}">
        <p14:creationId xmlns:p14="http://schemas.microsoft.com/office/powerpoint/2010/main" val="289162590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57BE194-8A15-46CC-8231-902DADF1D524}"/>
              </a:ext>
            </a:extLst>
          </p:cNvPr>
          <p:cNvSpPr>
            <a:spLocks noGrp="1"/>
          </p:cNvSpPr>
          <p:nvPr>
            <p:ph type="title"/>
          </p:nvPr>
        </p:nvSpPr>
        <p:spPr/>
        <p:txBody>
          <a:bodyPr/>
          <a:lstStyle/>
          <a:p>
            <a:r>
              <a:rPr lang="en-GB" dirty="0"/>
              <a:t>Supp. Fig. 1.</a:t>
            </a:r>
          </a:p>
        </p:txBody>
      </p:sp>
      <p:pic>
        <p:nvPicPr>
          <p:cNvPr id="5" name="Content Placeholder 4">
            <a:extLst>
              <a:ext uri="{FF2B5EF4-FFF2-40B4-BE49-F238E27FC236}">
                <a16:creationId xmlns:a16="http://schemas.microsoft.com/office/drawing/2014/main" id="{C56357DA-4BAF-4A0F-BFE9-C9CB0518DE8F}"/>
              </a:ext>
            </a:extLst>
          </p:cNvPr>
          <p:cNvPicPr>
            <a:picLocks noGrp="1" noChangeAspect="1"/>
          </p:cNvPicPr>
          <p:nvPr>
            <p:ph idx="1"/>
          </p:nvPr>
        </p:nvPicPr>
        <p:blipFill>
          <a:blip r:embed="rId3"/>
          <a:stretch>
            <a:fillRect/>
          </a:stretch>
        </p:blipFill>
        <p:spPr>
          <a:xfrm>
            <a:off x="1857254" y="1825625"/>
            <a:ext cx="8477492" cy="4351338"/>
          </a:xfrm>
          <a:prstGeom prst="rect">
            <a:avLst/>
          </a:prstGeom>
        </p:spPr>
      </p:pic>
    </p:spTree>
    <p:extLst>
      <p:ext uri="{BB962C8B-B14F-4D97-AF65-F5344CB8AC3E}">
        <p14:creationId xmlns:p14="http://schemas.microsoft.com/office/powerpoint/2010/main" val="390300662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DD6221A-798C-4876-84A9-509539D0F258}"/>
              </a:ext>
            </a:extLst>
          </p:cNvPr>
          <p:cNvSpPr>
            <a:spLocks noGrp="1"/>
          </p:cNvSpPr>
          <p:nvPr>
            <p:ph type="title"/>
          </p:nvPr>
        </p:nvSpPr>
        <p:spPr/>
        <p:txBody>
          <a:bodyPr/>
          <a:lstStyle/>
          <a:p>
            <a:r>
              <a:rPr lang="en-GB" dirty="0"/>
              <a:t>Supp. Fig. 2. </a:t>
            </a:r>
          </a:p>
        </p:txBody>
      </p:sp>
      <p:pic>
        <p:nvPicPr>
          <p:cNvPr id="4" name="Content Placeholder 3">
            <a:extLst>
              <a:ext uri="{FF2B5EF4-FFF2-40B4-BE49-F238E27FC236}">
                <a16:creationId xmlns:a16="http://schemas.microsoft.com/office/drawing/2014/main" id="{A5163E22-5E54-414D-B06F-91C34AC2C020}"/>
              </a:ext>
            </a:extLst>
          </p:cNvPr>
          <p:cNvPicPr>
            <a:picLocks noGrp="1" noChangeAspect="1"/>
          </p:cNvPicPr>
          <p:nvPr>
            <p:ph idx="1"/>
          </p:nvPr>
        </p:nvPicPr>
        <p:blipFill rotWithShape="1">
          <a:blip r:embed="rId3"/>
          <a:srcRect l="18000" r="17012"/>
          <a:stretch/>
        </p:blipFill>
        <p:spPr>
          <a:xfrm>
            <a:off x="3265445" y="1651229"/>
            <a:ext cx="5509260" cy="4351338"/>
          </a:xfrm>
          <a:prstGeom prst="rect">
            <a:avLst/>
          </a:prstGeom>
        </p:spPr>
      </p:pic>
      <p:sp>
        <p:nvSpPr>
          <p:cNvPr id="5" name="Freeform: Shape 4">
            <a:extLst>
              <a:ext uri="{FF2B5EF4-FFF2-40B4-BE49-F238E27FC236}">
                <a16:creationId xmlns:a16="http://schemas.microsoft.com/office/drawing/2014/main" id="{DC7F9D20-202C-AA65-5647-B978F6F044C2}"/>
              </a:ext>
            </a:extLst>
          </p:cNvPr>
          <p:cNvSpPr/>
          <p:nvPr/>
        </p:nvSpPr>
        <p:spPr>
          <a:xfrm>
            <a:off x="4392891" y="3696655"/>
            <a:ext cx="2427402" cy="2399983"/>
          </a:xfrm>
          <a:custGeom>
            <a:avLst/>
            <a:gdLst>
              <a:gd name="connsiteX0" fmla="*/ 664589 w 2427402"/>
              <a:gd name="connsiteY0" fmla="*/ 12792 h 2399983"/>
              <a:gd name="connsiteX1" fmla="*/ 240383 w 2427402"/>
              <a:gd name="connsiteY1" fmla="*/ 8079 h 2399983"/>
              <a:gd name="connsiteX2" fmla="*/ 183822 w 2427402"/>
              <a:gd name="connsiteY2" fmla="*/ 26933 h 2399983"/>
              <a:gd name="connsiteX3" fmla="*/ 61274 w 2427402"/>
              <a:gd name="connsiteY3" fmla="*/ 102347 h 2399983"/>
              <a:gd name="connsiteX4" fmla="*/ 18853 w 2427402"/>
              <a:gd name="connsiteY4" fmla="*/ 220182 h 2399983"/>
              <a:gd name="connsiteX5" fmla="*/ 0 w 2427402"/>
              <a:gd name="connsiteY5" fmla="*/ 295597 h 2399983"/>
              <a:gd name="connsiteX6" fmla="*/ 14140 w 2427402"/>
              <a:gd name="connsiteY6" fmla="*/ 531267 h 2399983"/>
              <a:gd name="connsiteX7" fmla="*/ 32994 w 2427402"/>
              <a:gd name="connsiteY7" fmla="*/ 587827 h 2399983"/>
              <a:gd name="connsiteX8" fmla="*/ 37707 w 2427402"/>
              <a:gd name="connsiteY8" fmla="*/ 620821 h 2399983"/>
              <a:gd name="connsiteX9" fmla="*/ 80128 w 2427402"/>
              <a:gd name="connsiteY9" fmla="*/ 785790 h 2399983"/>
              <a:gd name="connsiteX10" fmla="*/ 84841 w 2427402"/>
              <a:gd name="connsiteY10" fmla="*/ 837638 h 2399983"/>
              <a:gd name="connsiteX11" fmla="*/ 98981 w 2427402"/>
              <a:gd name="connsiteY11" fmla="*/ 894199 h 2399983"/>
              <a:gd name="connsiteX12" fmla="*/ 42420 w 2427402"/>
              <a:gd name="connsiteY12" fmla="*/ 1148722 h 2399983"/>
              <a:gd name="connsiteX13" fmla="*/ 28280 w 2427402"/>
              <a:gd name="connsiteY13" fmla="*/ 1233564 h 2399983"/>
              <a:gd name="connsiteX14" fmla="*/ 37707 w 2427402"/>
              <a:gd name="connsiteY14" fmla="*/ 1271271 h 2399983"/>
              <a:gd name="connsiteX15" fmla="*/ 70701 w 2427402"/>
              <a:gd name="connsiteY15" fmla="*/ 1327832 h 2399983"/>
              <a:gd name="connsiteX16" fmla="*/ 183822 w 2427402"/>
              <a:gd name="connsiteY16" fmla="*/ 1412673 h 2399983"/>
              <a:gd name="connsiteX17" fmla="*/ 240383 w 2427402"/>
              <a:gd name="connsiteY17" fmla="*/ 1445667 h 2399983"/>
              <a:gd name="connsiteX18" fmla="*/ 367645 w 2427402"/>
              <a:gd name="connsiteY18" fmla="*/ 1492801 h 2399983"/>
              <a:gd name="connsiteX19" fmla="*/ 490194 w 2427402"/>
              <a:gd name="connsiteY19" fmla="*/ 1516368 h 2399983"/>
              <a:gd name="connsiteX20" fmla="*/ 570321 w 2427402"/>
              <a:gd name="connsiteY20" fmla="*/ 1521081 h 2399983"/>
              <a:gd name="connsiteX21" fmla="*/ 608029 w 2427402"/>
              <a:gd name="connsiteY21" fmla="*/ 1530508 h 2399983"/>
              <a:gd name="connsiteX22" fmla="*/ 631596 w 2427402"/>
              <a:gd name="connsiteY22" fmla="*/ 1587069 h 2399983"/>
              <a:gd name="connsiteX23" fmla="*/ 683443 w 2427402"/>
              <a:gd name="connsiteY23" fmla="*/ 1686050 h 2399983"/>
              <a:gd name="connsiteX24" fmla="*/ 655163 w 2427402"/>
              <a:gd name="connsiteY24" fmla="*/ 1822739 h 2399983"/>
              <a:gd name="connsiteX25" fmla="*/ 579748 w 2427402"/>
              <a:gd name="connsiteY25" fmla="*/ 1907580 h 2399983"/>
              <a:gd name="connsiteX26" fmla="*/ 565608 w 2427402"/>
              <a:gd name="connsiteY26" fmla="*/ 1945287 h 2399983"/>
              <a:gd name="connsiteX27" fmla="*/ 612742 w 2427402"/>
              <a:gd name="connsiteY27" fmla="*/ 2124397 h 2399983"/>
              <a:gd name="connsiteX28" fmla="*/ 678730 w 2427402"/>
              <a:gd name="connsiteY28" fmla="*/ 2180957 h 2399983"/>
              <a:gd name="connsiteX29" fmla="*/ 909686 w 2427402"/>
              <a:gd name="connsiteY29" fmla="*/ 2275225 h 2399983"/>
              <a:gd name="connsiteX30" fmla="*/ 1484721 w 2427402"/>
              <a:gd name="connsiteY30" fmla="*/ 2374207 h 2399983"/>
              <a:gd name="connsiteX31" fmla="*/ 1668544 w 2427402"/>
              <a:gd name="connsiteY31" fmla="*/ 2397774 h 2399983"/>
              <a:gd name="connsiteX32" fmla="*/ 2073897 w 2427402"/>
              <a:gd name="connsiteY32" fmla="*/ 2393060 h 2399983"/>
              <a:gd name="connsiteX33" fmla="*/ 2356701 w 2427402"/>
              <a:gd name="connsiteY33" fmla="*/ 2289366 h 2399983"/>
              <a:gd name="connsiteX34" fmla="*/ 2399121 w 2427402"/>
              <a:gd name="connsiteY34" fmla="*/ 2237518 h 2399983"/>
              <a:gd name="connsiteX35" fmla="*/ 2427402 w 2427402"/>
              <a:gd name="connsiteY35" fmla="*/ 2034842 h 2399983"/>
              <a:gd name="connsiteX36" fmla="*/ 2413262 w 2427402"/>
              <a:gd name="connsiteY36" fmla="*/ 1846306 h 2399983"/>
              <a:gd name="connsiteX37" fmla="*/ 2384981 w 2427402"/>
              <a:gd name="connsiteY37" fmla="*/ 1770891 h 2399983"/>
              <a:gd name="connsiteX38" fmla="*/ 2262433 w 2427402"/>
              <a:gd name="connsiteY38" fmla="*/ 1577642 h 2399983"/>
              <a:gd name="connsiteX39" fmla="*/ 2168165 w 2427402"/>
              <a:gd name="connsiteY39" fmla="*/ 1445667 h 2399983"/>
              <a:gd name="connsiteX40" fmla="*/ 2125744 w 2427402"/>
              <a:gd name="connsiteY40" fmla="*/ 1384392 h 2399983"/>
              <a:gd name="connsiteX41" fmla="*/ 2026763 w 2427402"/>
              <a:gd name="connsiteY41" fmla="*/ 1261844 h 2399983"/>
              <a:gd name="connsiteX42" fmla="*/ 1937208 w 2427402"/>
              <a:gd name="connsiteY42" fmla="*/ 1153436 h 2399983"/>
              <a:gd name="connsiteX43" fmla="*/ 1871220 w 2427402"/>
              <a:gd name="connsiteY43" fmla="*/ 1063881 h 2399983"/>
              <a:gd name="connsiteX44" fmla="*/ 1781666 w 2427402"/>
              <a:gd name="connsiteY44" fmla="*/ 870632 h 2399983"/>
              <a:gd name="connsiteX45" fmla="*/ 1743958 w 2427402"/>
              <a:gd name="connsiteY45" fmla="*/ 724516 h 2399983"/>
              <a:gd name="connsiteX46" fmla="*/ 1729818 w 2427402"/>
              <a:gd name="connsiteY46" fmla="*/ 667955 h 2399983"/>
              <a:gd name="connsiteX47" fmla="*/ 1701538 w 2427402"/>
              <a:gd name="connsiteY47" fmla="*/ 564260 h 2399983"/>
              <a:gd name="connsiteX48" fmla="*/ 1692111 w 2427402"/>
              <a:gd name="connsiteY48" fmla="*/ 498273 h 2399983"/>
              <a:gd name="connsiteX49" fmla="*/ 1640264 w 2427402"/>
              <a:gd name="connsiteY49" fmla="*/ 338017 h 2399983"/>
              <a:gd name="connsiteX50" fmla="*/ 1578989 w 2427402"/>
              <a:gd name="connsiteY50" fmla="*/ 220182 h 2399983"/>
              <a:gd name="connsiteX51" fmla="*/ 1555422 w 2427402"/>
              <a:gd name="connsiteY51" fmla="*/ 187188 h 2399983"/>
              <a:gd name="connsiteX52" fmla="*/ 1522429 w 2427402"/>
              <a:gd name="connsiteY52" fmla="*/ 163621 h 2399983"/>
              <a:gd name="connsiteX53" fmla="*/ 1428161 w 2427402"/>
              <a:gd name="connsiteY53" fmla="*/ 116487 h 2399983"/>
              <a:gd name="connsiteX54" fmla="*/ 1310325 w 2427402"/>
              <a:gd name="connsiteY54" fmla="*/ 74067 h 2399983"/>
              <a:gd name="connsiteX55" fmla="*/ 1234911 w 2427402"/>
              <a:gd name="connsiteY55" fmla="*/ 64640 h 2399983"/>
              <a:gd name="connsiteX56" fmla="*/ 1135930 w 2427402"/>
              <a:gd name="connsiteY56" fmla="*/ 50500 h 2399983"/>
              <a:gd name="connsiteX57" fmla="*/ 1069942 w 2427402"/>
              <a:gd name="connsiteY57" fmla="*/ 41073 h 2399983"/>
              <a:gd name="connsiteX58" fmla="*/ 744717 w 2427402"/>
              <a:gd name="connsiteY58" fmla="*/ 31646 h 2399983"/>
              <a:gd name="connsiteX59" fmla="*/ 702297 w 2427402"/>
              <a:gd name="connsiteY59" fmla="*/ 26933 h 2399983"/>
              <a:gd name="connsiteX60" fmla="*/ 664589 w 2427402"/>
              <a:gd name="connsiteY60" fmla="*/ 12792 h 239998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Lst>
            <a:rect l="l" t="t" r="r" b="b"/>
            <a:pathLst>
              <a:path w="2427402" h="2399983">
                <a:moveTo>
                  <a:pt x="664589" y="12792"/>
                </a:moveTo>
                <a:cubicBezTo>
                  <a:pt x="587604" y="9650"/>
                  <a:pt x="413820" y="-11192"/>
                  <a:pt x="240383" y="8079"/>
                </a:cubicBezTo>
                <a:cubicBezTo>
                  <a:pt x="220631" y="10274"/>
                  <a:pt x="202013" y="18929"/>
                  <a:pt x="183822" y="26933"/>
                </a:cubicBezTo>
                <a:cubicBezTo>
                  <a:pt x="133119" y="49242"/>
                  <a:pt x="106877" y="70775"/>
                  <a:pt x="61274" y="102347"/>
                </a:cubicBezTo>
                <a:cubicBezTo>
                  <a:pt x="42464" y="149371"/>
                  <a:pt x="34162" y="167449"/>
                  <a:pt x="18853" y="220182"/>
                </a:cubicBezTo>
                <a:cubicBezTo>
                  <a:pt x="11629" y="245066"/>
                  <a:pt x="6284" y="270459"/>
                  <a:pt x="0" y="295597"/>
                </a:cubicBezTo>
                <a:cubicBezTo>
                  <a:pt x="4713" y="374154"/>
                  <a:pt x="5311" y="453066"/>
                  <a:pt x="14140" y="531267"/>
                </a:cubicBezTo>
                <a:cubicBezTo>
                  <a:pt x="16370" y="551015"/>
                  <a:pt x="27936" y="568608"/>
                  <a:pt x="32994" y="587827"/>
                </a:cubicBezTo>
                <a:cubicBezTo>
                  <a:pt x="35821" y="598571"/>
                  <a:pt x="34784" y="610103"/>
                  <a:pt x="37707" y="620821"/>
                </a:cubicBezTo>
                <a:cubicBezTo>
                  <a:pt x="88261" y="806190"/>
                  <a:pt x="34661" y="558461"/>
                  <a:pt x="80128" y="785790"/>
                </a:cubicBezTo>
                <a:cubicBezTo>
                  <a:pt x="81699" y="803073"/>
                  <a:pt x="81868" y="820541"/>
                  <a:pt x="84841" y="837638"/>
                </a:cubicBezTo>
                <a:cubicBezTo>
                  <a:pt x="88171" y="856785"/>
                  <a:pt x="100079" y="874796"/>
                  <a:pt x="98981" y="894199"/>
                </a:cubicBezTo>
                <a:cubicBezTo>
                  <a:pt x="89486" y="1061950"/>
                  <a:pt x="90367" y="1044840"/>
                  <a:pt x="42420" y="1148722"/>
                </a:cubicBezTo>
                <a:cubicBezTo>
                  <a:pt x="40197" y="1159838"/>
                  <a:pt x="27323" y="1218253"/>
                  <a:pt x="28280" y="1233564"/>
                </a:cubicBezTo>
                <a:cubicBezTo>
                  <a:pt x="29088" y="1246495"/>
                  <a:pt x="32390" y="1259456"/>
                  <a:pt x="37707" y="1271271"/>
                </a:cubicBezTo>
                <a:cubicBezTo>
                  <a:pt x="46664" y="1291175"/>
                  <a:pt x="57066" y="1310788"/>
                  <a:pt x="70701" y="1327832"/>
                </a:cubicBezTo>
                <a:cubicBezTo>
                  <a:pt x="93829" y="1356742"/>
                  <a:pt x="157956" y="1396387"/>
                  <a:pt x="183822" y="1412673"/>
                </a:cubicBezTo>
                <a:cubicBezTo>
                  <a:pt x="202293" y="1424303"/>
                  <a:pt x="220860" y="1435906"/>
                  <a:pt x="240383" y="1445667"/>
                </a:cubicBezTo>
                <a:cubicBezTo>
                  <a:pt x="283798" y="1467374"/>
                  <a:pt x="321195" y="1480295"/>
                  <a:pt x="367645" y="1492801"/>
                </a:cubicBezTo>
                <a:cubicBezTo>
                  <a:pt x="404088" y="1502613"/>
                  <a:pt x="452533" y="1512602"/>
                  <a:pt x="490194" y="1516368"/>
                </a:cubicBezTo>
                <a:cubicBezTo>
                  <a:pt x="516816" y="1519030"/>
                  <a:pt x="543612" y="1519510"/>
                  <a:pt x="570321" y="1521081"/>
                </a:cubicBezTo>
                <a:cubicBezTo>
                  <a:pt x="582890" y="1524223"/>
                  <a:pt x="599213" y="1521014"/>
                  <a:pt x="608029" y="1530508"/>
                </a:cubicBezTo>
                <a:cubicBezTo>
                  <a:pt x="621927" y="1545475"/>
                  <a:pt x="622148" y="1568961"/>
                  <a:pt x="631596" y="1587069"/>
                </a:cubicBezTo>
                <a:cubicBezTo>
                  <a:pt x="698580" y="1715457"/>
                  <a:pt x="636407" y="1568462"/>
                  <a:pt x="683443" y="1686050"/>
                </a:cubicBezTo>
                <a:cubicBezTo>
                  <a:pt x="689954" y="1744655"/>
                  <a:pt x="697250" y="1754597"/>
                  <a:pt x="655163" y="1822739"/>
                </a:cubicBezTo>
                <a:cubicBezTo>
                  <a:pt x="580881" y="1943005"/>
                  <a:pt x="603838" y="1849765"/>
                  <a:pt x="579748" y="1907580"/>
                </a:cubicBezTo>
                <a:cubicBezTo>
                  <a:pt x="574585" y="1919971"/>
                  <a:pt x="570321" y="1932718"/>
                  <a:pt x="565608" y="1945287"/>
                </a:cubicBezTo>
                <a:cubicBezTo>
                  <a:pt x="574172" y="1996670"/>
                  <a:pt x="569260" y="2078626"/>
                  <a:pt x="612742" y="2124397"/>
                </a:cubicBezTo>
                <a:cubicBezTo>
                  <a:pt x="632695" y="2145400"/>
                  <a:pt x="654317" y="2165360"/>
                  <a:pt x="678730" y="2180957"/>
                </a:cubicBezTo>
                <a:cubicBezTo>
                  <a:pt x="743772" y="2222512"/>
                  <a:pt x="836763" y="2255634"/>
                  <a:pt x="909686" y="2275225"/>
                </a:cubicBezTo>
                <a:cubicBezTo>
                  <a:pt x="1098406" y="2325926"/>
                  <a:pt x="1290877" y="2349355"/>
                  <a:pt x="1484721" y="2374207"/>
                </a:cubicBezTo>
                <a:lnTo>
                  <a:pt x="1668544" y="2397774"/>
                </a:lnTo>
                <a:cubicBezTo>
                  <a:pt x="1803662" y="2396203"/>
                  <a:pt x="1939419" y="2406287"/>
                  <a:pt x="2073897" y="2393060"/>
                </a:cubicBezTo>
                <a:cubicBezTo>
                  <a:pt x="2162748" y="2384321"/>
                  <a:pt x="2274327" y="2327120"/>
                  <a:pt x="2356701" y="2289366"/>
                </a:cubicBezTo>
                <a:cubicBezTo>
                  <a:pt x="2370841" y="2272083"/>
                  <a:pt x="2390717" y="2258206"/>
                  <a:pt x="2399121" y="2237518"/>
                </a:cubicBezTo>
                <a:cubicBezTo>
                  <a:pt x="2416191" y="2195498"/>
                  <a:pt x="2423488" y="2077892"/>
                  <a:pt x="2427402" y="2034842"/>
                </a:cubicBezTo>
                <a:cubicBezTo>
                  <a:pt x="2422689" y="1971997"/>
                  <a:pt x="2423262" y="1908529"/>
                  <a:pt x="2413262" y="1846306"/>
                </a:cubicBezTo>
                <a:cubicBezTo>
                  <a:pt x="2409002" y="1819798"/>
                  <a:pt x="2395557" y="1795568"/>
                  <a:pt x="2384981" y="1770891"/>
                </a:cubicBezTo>
                <a:cubicBezTo>
                  <a:pt x="2352001" y="1693937"/>
                  <a:pt x="2316017" y="1655246"/>
                  <a:pt x="2262433" y="1577642"/>
                </a:cubicBezTo>
                <a:cubicBezTo>
                  <a:pt x="2165474" y="1437219"/>
                  <a:pt x="2279293" y="1601247"/>
                  <a:pt x="2168165" y="1445667"/>
                </a:cubicBezTo>
                <a:cubicBezTo>
                  <a:pt x="2153726" y="1425452"/>
                  <a:pt x="2141911" y="1403253"/>
                  <a:pt x="2125744" y="1384392"/>
                </a:cubicBezTo>
                <a:cubicBezTo>
                  <a:pt x="1980329" y="1214743"/>
                  <a:pt x="2146370" y="1411354"/>
                  <a:pt x="2026763" y="1261844"/>
                </a:cubicBezTo>
                <a:cubicBezTo>
                  <a:pt x="1997483" y="1225244"/>
                  <a:pt x="1966889" y="1189712"/>
                  <a:pt x="1937208" y="1153436"/>
                </a:cubicBezTo>
                <a:cubicBezTo>
                  <a:pt x="1914945" y="1126226"/>
                  <a:pt x="1888650" y="1095005"/>
                  <a:pt x="1871220" y="1063881"/>
                </a:cubicBezTo>
                <a:cubicBezTo>
                  <a:pt x="1851884" y="1029353"/>
                  <a:pt x="1787480" y="893162"/>
                  <a:pt x="1781666" y="870632"/>
                </a:cubicBezTo>
                <a:cubicBezTo>
                  <a:pt x="1769097" y="821927"/>
                  <a:pt x="1756424" y="773248"/>
                  <a:pt x="1743958" y="724516"/>
                </a:cubicBezTo>
                <a:cubicBezTo>
                  <a:pt x="1739142" y="705688"/>
                  <a:pt x="1736642" y="686152"/>
                  <a:pt x="1729818" y="667955"/>
                </a:cubicBezTo>
                <a:cubicBezTo>
                  <a:pt x="1710754" y="617118"/>
                  <a:pt x="1713506" y="630080"/>
                  <a:pt x="1701538" y="564260"/>
                </a:cubicBezTo>
                <a:cubicBezTo>
                  <a:pt x="1696456" y="536307"/>
                  <a:pt x="1698290" y="524534"/>
                  <a:pt x="1692111" y="498273"/>
                </a:cubicBezTo>
                <a:cubicBezTo>
                  <a:pt x="1679019" y="442630"/>
                  <a:pt x="1660118" y="392616"/>
                  <a:pt x="1640264" y="338017"/>
                </a:cubicBezTo>
                <a:cubicBezTo>
                  <a:pt x="1622803" y="289999"/>
                  <a:pt x="1611275" y="265383"/>
                  <a:pt x="1578989" y="220182"/>
                </a:cubicBezTo>
                <a:cubicBezTo>
                  <a:pt x="1571133" y="209184"/>
                  <a:pt x="1564979" y="196745"/>
                  <a:pt x="1555422" y="187188"/>
                </a:cubicBezTo>
                <a:cubicBezTo>
                  <a:pt x="1545865" y="177631"/>
                  <a:pt x="1533856" y="170838"/>
                  <a:pt x="1522429" y="163621"/>
                </a:cubicBezTo>
                <a:cubicBezTo>
                  <a:pt x="1454569" y="120761"/>
                  <a:pt x="1486123" y="140198"/>
                  <a:pt x="1428161" y="116487"/>
                </a:cubicBezTo>
                <a:cubicBezTo>
                  <a:pt x="1377671" y="95833"/>
                  <a:pt x="1361334" y="83513"/>
                  <a:pt x="1310325" y="74067"/>
                </a:cubicBezTo>
                <a:cubicBezTo>
                  <a:pt x="1285415" y="69454"/>
                  <a:pt x="1259926" y="68643"/>
                  <a:pt x="1234911" y="64640"/>
                </a:cubicBezTo>
                <a:cubicBezTo>
                  <a:pt x="1050062" y="35063"/>
                  <a:pt x="1368825" y="77372"/>
                  <a:pt x="1135930" y="50500"/>
                </a:cubicBezTo>
                <a:cubicBezTo>
                  <a:pt x="1113857" y="47953"/>
                  <a:pt x="1092136" y="42143"/>
                  <a:pt x="1069942" y="41073"/>
                </a:cubicBezTo>
                <a:cubicBezTo>
                  <a:pt x="961614" y="35852"/>
                  <a:pt x="853125" y="34788"/>
                  <a:pt x="744717" y="31646"/>
                </a:cubicBezTo>
                <a:cubicBezTo>
                  <a:pt x="730577" y="30075"/>
                  <a:pt x="716359" y="29096"/>
                  <a:pt x="702297" y="26933"/>
                </a:cubicBezTo>
                <a:cubicBezTo>
                  <a:pt x="669180" y="21838"/>
                  <a:pt x="741574" y="15934"/>
                  <a:pt x="664589" y="12792"/>
                </a:cubicBezTo>
                <a:close/>
              </a:path>
            </a:pathLst>
          </a:cu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 name="Freeform: Shape 5">
            <a:extLst>
              <a:ext uri="{FF2B5EF4-FFF2-40B4-BE49-F238E27FC236}">
                <a16:creationId xmlns:a16="http://schemas.microsoft.com/office/drawing/2014/main" id="{AAFEF0FD-4F31-5F2F-3817-DC5645D9C27F}"/>
              </a:ext>
            </a:extLst>
          </p:cNvPr>
          <p:cNvSpPr/>
          <p:nvPr/>
        </p:nvSpPr>
        <p:spPr>
          <a:xfrm>
            <a:off x="7070103" y="3453603"/>
            <a:ext cx="383162" cy="774319"/>
          </a:xfrm>
          <a:custGeom>
            <a:avLst/>
            <a:gdLst>
              <a:gd name="connsiteX0" fmla="*/ 70701 w 383162"/>
              <a:gd name="connsiteY0" fmla="*/ 1321 h 774319"/>
              <a:gd name="connsiteX1" fmla="*/ 47134 w 383162"/>
              <a:gd name="connsiteY1" fmla="*/ 6034 h 774319"/>
              <a:gd name="connsiteX2" fmla="*/ 23567 w 383162"/>
              <a:gd name="connsiteY2" fmla="*/ 43741 h 774319"/>
              <a:gd name="connsiteX3" fmla="*/ 9427 w 383162"/>
              <a:gd name="connsiteY3" fmla="*/ 81449 h 774319"/>
              <a:gd name="connsiteX4" fmla="*/ 0 w 383162"/>
              <a:gd name="connsiteY4" fmla="*/ 119156 h 774319"/>
              <a:gd name="connsiteX5" fmla="*/ 9427 w 383162"/>
              <a:gd name="connsiteY5" fmla="*/ 284125 h 774319"/>
              <a:gd name="connsiteX6" fmla="*/ 14140 w 383162"/>
              <a:gd name="connsiteY6" fmla="*/ 317119 h 774319"/>
              <a:gd name="connsiteX7" fmla="*/ 23567 w 383162"/>
              <a:gd name="connsiteY7" fmla="*/ 364253 h 774319"/>
              <a:gd name="connsiteX8" fmla="*/ 28281 w 383162"/>
              <a:gd name="connsiteY8" fmla="*/ 444381 h 774319"/>
              <a:gd name="connsiteX9" fmla="*/ 37707 w 383162"/>
              <a:gd name="connsiteY9" fmla="*/ 467948 h 774319"/>
              <a:gd name="connsiteX10" fmla="*/ 47134 w 383162"/>
              <a:gd name="connsiteY10" fmla="*/ 519795 h 774319"/>
              <a:gd name="connsiteX11" fmla="*/ 51848 w 383162"/>
              <a:gd name="connsiteY11" fmla="*/ 538649 h 774319"/>
              <a:gd name="connsiteX12" fmla="*/ 56561 w 383162"/>
              <a:gd name="connsiteY12" fmla="*/ 566929 h 774319"/>
              <a:gd name="connsiteX13" fmla="*/ 61274 w 383162"/>
              <a:gd name="connsiteY13" fmla="*/ 609350 h 774319"/>
              <a:gd name="connsiteX14" fmla="*/ 80128 w 383162"/>
              <a:gd name="connsiteY14" fmla="*/ 651770 h 774319"/>
              <a:gd name="connsiteX15" fmla="*/ 94268 w 383162"/>
              <a:gd name="connsiteY15" fmla="*/ 684764 h 774319"/>
              <a:gd name="connsiteX16" fmla="*/ 108408 w 383162"/>
              <a:gd name="connsiteY16" fmla="*/ 698904 h 774319"/>
              <a:gd name="connsiteX17" fmla="*/ 122549 w 383162"/>
              <a:gd name="connsiteY17" fmla="*/ 722471 h 774319"/>
              <a:gd name="connsiteX18" fmla="*/ 136689 w 383162"/>
              <a:gd name="connsiteY18" fmla="*/ 731898 h 774319"/>
              <a:gd name="connsiteX19" fmla="*/ 150829 w 383162"/>
              <a:gd name="connsiteY19" fmla="*/ 750752 h 774319"/>
              <a:gd name="connsiteX20" fmla="*/ 193250 w 383162"/>
              <a:gd name="connsiteY20" fmla="*/ 764892 h 774319"/>
              <a:gd name="connsiteX21" fmla="*/ 320511 w 383162"/>
              <a:gd name="connsiteY21" fmla="*/ 774319 h 774319"/>
              <a:gd name="connsiteX22" fmla="*/ 367645 w 383162"/>
              <a:gd name="connsiteY22" fmla="*/ 769605 h 774319"/>
              <a:gd name="connsiteX23" fmla="*/ 372359 w 383162"/>
              <a:gd name="connsiteY23" fmla="*/ 680051 h 774319"/>
              <a:gd name="connsiteX24" fmla="*/ 362932 w 383162"/>
              <a:gd name="connsiteY24" fmla="*/ 661197 h 774319"/>
              <a:gd name="connsiteX25" fmla="*/ 344078 w 383162"/>
              <a:gd name="connsiteY25" fmla="*/ 656484 h 774319"/>
              <a:gd name="connsiteX26" fmla="*/ 325225 w 383162"/>
              <a:gd name="connsiteY26" fmla="*/ 637630 h 774319"/>
              <a:gd name="connsiteX27" fmla="*/ 306371 w 383162"/>
              <a:gd name="connsiteY27" fmla="*/ 623490 h 774319"/>
              <a:gd name="connsiteX28" fmla="*/ 301658 w 383162"/>
              <a:gd name="connsiteY28" fmla="*/ 609350 h 774319"/>
              <a:gd name="connsiteX29" fmla="*/ 282804 w 383162"/>
              <a:gd name="connsiteY29" fmla="*/ 562216 h 774319"/>
              <a:gd name="connsiteX30" fmla="*/ 273377 w 383162"/>
              <a:gd name="connsiteY30" fmla="*/ 510368 h 774319"/>
              <a:gd name="connsiteX31" fmla="*/ 245097 w 383162"/>
              <a:gd name="connsiteY31" fmla="*/ 482088 h 774319"/>
              <a:gd name="connsiteX32" fmla="*/ 230957 w 383162"/>
              <a:gd name="connsiteY32" fmla="*/ 463234 h 774319"/>
              <a:gd name="connsiteX33" fmla="*/ 226243 w 383162"/>
              <a:gd name="connsiteY33" fmla="*/ 444381 h 774319"/>
              <a:gd name="connsiteX34" fmla="*/ 212103 w 383162"/>
              <a:gd name="connsiteY34" fmla="*/ 401960 h 774319"/>
              <a:gd name="connsiteX35" fmla="*/ 202676 w 383162"/>
              <a:gd name="connsiteY35" fmla="*/ 368966 h 774319"/>
              <a:gd name="connsiteX36" fmla="*/ 193250 w 383162"/>
              <a:gd name="connsiteY36" fmla="*/ 326545 h 774319"/>
              <a:gd name="connsiteX37" fmla="*/ 164969 w 383162"/>
              <a:gd name="connsiteY37" fmla="*/ 288838 h 774319"/>
              <a:gd name="connsiteX38" fmla="*/ 155542 w 383162"/>
              <a:gd name="connsiteY38" fmla="*/ 274698 h 774319"/>
              <a:gd name="connsiteX39" fmla="*/ 141402 w 383162"/>
              <a:gd name="connsiteY39" fmla="*/ 218137 h 774319"/>
              <a:gd name="connsiteX40" fmla="*/ 150829 w 383162"/>
              <a:gd name="connsiteY40" fmla="*/ 114442 h 774319"/>
              <a:gd name="connsiteX41" fmla="*/ 136689 w 383162"/>
              <a:gd name="connsiteY41" fmla="*/ 20174 h 774319"/>
              <a:gd name="connsiteX42" fmla="*/ 117835 w 383162"/>
              <a:gd name="connsiteY42" fmla="*/ 1321 h 774319"/>
              <a:gd name="connsiteX43" fmla="*/ 70701 w 383162"/>
              <a:gd name="connsiteY43" fmla="*/ 1321 h 77431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Lst>
            <a:rect l="l" t="t" r="r" b="b"/>
            <a:pathLst>
              <a:path w="383162" h="774319">
                <a:moveTo>
                  <a:pt x="70701" y="1321"/>
                </a:moveTo>
                <a:cubicBezTo>
                  <a:pt x="58918" y="2106"/>
                  <a:pt x="53927" y="1788"/>
                  <a:pt x="47134" y="6034"/>
                </a:cubicBezTo>
                <a:cubicBezTo>
                  <a:pt x="39007" y="11114"/>
                  <a:pt x="27359" y="35209"/>
                  <a:pt x="23567" y="43741"/>
                </a:cubicBezTo>
                <a:cubicBezTo>
                  <a:pt x="21091" y="49312"/>
                  <a:pt x="11650" y="72558"/>
                  <a:pt x="9427" y="81449"/>
                </a:cubicBezTo>
                <a:lnTo>
                  <a:pt x="0" y="119156"/>
                </a:lnTo>
                <a:cubicBezTo>
                  <a:pt x="6338" y="302973"/>
                  <a:pt x="-3054" y="202997"/>
                  <a:pt x="9427" y="284125"/>
                </a:cubicBezTo>
                <a:cubicBezTo>
                  <a:pt x="11116" y="295105"/>
                  <a:pt x="12209" y="306178"/>
                  <a:pt x="14140" y="317119"/>
                </a:cubicBezTo>
                <a:cubicBezTo>
                  <a:pt x="16924" y="332898"/>
                  <a:pt x="23567" y="364253"/>
                  <a:pt x="23567" y="364253"/>
                </a:cubicBezTo>
                <a:cubicBezTo>
                  <a:pt x="25138" y="390962"/>
                  <a:pt x="24666" y="417871"/>
                  <a:pt x="28281" y="444381"/>
                </a:cubicBezTo>
                <a:cubicBezTo>
                  <a:pt x="29424" y="452764"/>
                  <a:pt x="35031" y="459921"/>
                  <a:pt x="37707" y="467948"/>
                </a:cubicBezTo>
                <a:cubicBezTo>
                  <a:pt x="44124" y="487200"/>
                  <a:pt x="43205" y="498188"/>
                  <a:pt x="47134" y="519795"/>
                </a:cubicBezTo>
                <a:cubicBezTo>
                  <a:pt x="48293" y="526169"/>
                  <a:pt x="50578" y="532297"/>
                  <a:pt x="51848" y="538649"/>
                </a:cubicBezTo>
                <a:cubicBezTo>
                  <a:pt x="53722" y="548020"/>
                  <a:pt x="55298" y="557456"/>
                  <a:pt x="56561" y="566929"/>
                </a:cubicBezTo>
                <a:cubicBezTo>
                  <a:pt x="58441" y="581032"/>
                  <a:pt x="58293" y="595438"/>
                  <a:pt x="61274" y="609350"/>
                </a:cubicBezTo>
                <a:cubicBezTo>
                  <a:pt x="64028" y="622202"/>
                  <a:pt x="74626" y="639665"/>
                  <a:pt x="80128" y="651770"/>
                </a:cubicBezTo>
                <a:cubicBezTo>
                  <a:pt x="85079" y="662663"/>
                  <a:pt x="88112" y="674504"/>
                  <a:pt x="94268" y="684764"/>
                </a:cubicBezTo>
                <a:cubicBezTo>
                  <a:pt x="97697" y="690480"/>
                  <a:pt x="104409" y="693572"/>
                  <a:pt x="108408" y="698904"/>
                </a:cubicBezTo>
                <a:cubicBezTo>
                  <a:pt x="113905" y="706233"/>
                  <a:pt x="116587" y="715515"/>
                  <a:pt x="122549" y="722471"/>
                </a:cubicBezTo>
                <a:cubicBezTo>
                  <a:pt x="126236" y="726772"/>
                  <a:pt x="132683" y="727892"/>
                  <a:pt x="136689" y="731898"/>
                </a:cubicBezTo>
                <a:cubicBezTo>
                  <a:pt x="142244" y="737453"/>
                  <a:pt x="144864" y="745640"/>
                  <a:pt x="150829" y="750752"/>
                </a:cubicBezTo>
                <a:cubicBezTo>
                  <a:pt x="161880" y="760224"/>
                  <a:pt x="179860" y="762832"/>
                  <a:pt x="193250" y="764892"/>
                </a:cubicBezTo>
                <a:cubicBezTo>
                  <a:pt x="241409" y="772301"/>
                  <a:pt x="263642" y="771325"/>
                  <a:pt x="320511" y="774319"/>
                </a:cubicBezTo>
                <a:cubicBezTo>
                  <a:pt x="336222" y="772748"/>
                  <a:pt x="352908" y="775273"/>
                  <a:pt x="367645" y="769605"/>
                </a:cubicBezTo>
                <a:cubicBezTo>
                  <a:pt x="399448" y="757373"/>
                  <a:pt x="372545" y="680935"/>
                  <a:pt x="372359" y="680051"/>
                </a:cubicBezTo>
                <a:cubicBezTo>
                  <a:pt x="370911" y="673175"/>
                  <a:pt x="368330" y="665695"/>
                  <a:pt x="362932" y="661197"/>
                </a:cubicBezTo>
                <a:cubicBezTo>
                  <a:pt x="357955" y="657050"/>
                  <a:pt x="350363" y="658055"/>
                  <a:pt x="344078" y="656484"/>
                </a:cubicBezTo>
                <a:cubicBezTo>
                  <a:pt x="337794" y="650199"/>
                  <a:pt x="331914" y="643483"/>
                  <a:pt x="325225" y="637630"/>
                </a:cubicBezTo>
                <a:cubicBezTo>
                  <a:pt x="319313" y="632457"/>
                  <a:pt x="311400" y="629525"/>
                  <a:pt x="306371" y="623490"/>
                </a:cubicBezTo>
                <a:cubicBezTo>
                  <a:pt x="303190" y="619673"/>
                  <a:pt x="303676" y="613890"/>
                  <a:pt x="301658" y="609350"/>
                </a:cubicBezTo>
                <a:cubicBezTo>
                  <a:pt x="287376" y="577214"/>
                  <a:pt x="288382" y="590102"/>
                  <a:pt x="282804" y="562216"/>
                </a:cubicBezTo>
                <a:cubicBezTo>
                  <a:pt x="279359" y="544991"/>
                  <a:pt x="280857" y="526262"/>
                  <a:pt x="273377" y="510368"/>
                </a:cubicBezTo>
                <a:cubicBezTo>
                  <a:pt x="267701" y="498306"/>
                  <a:pt x="253096" y="492753"/>
                  <a:pt x="245097" y="482088"/>
                </a:cubicBezTo>
                <a:lnTo>
                  <a:pt x="230957" y="463234"/>
                </a:lnTo>
                <a:cubicBezTo>
                  <a:pt x="229386" y="456950"/>
                  <a:pt x="228148" y="450572"/>
                  <a:pt x="226243" y="444381"/>
                </a:cubicBezTo>
                <a:cubicBezTo>
                  <a:pt x="221859" y="430135"/>
                  <a:pt x="215718" y="416420"/>
                  <a:pt x="212103" y="401960"/>
                </a:cubicBezTo>
                <a:cubicBezTo>
                  <a:pt x="206185" y="378286"/>
                  <a:pt x="209439" y="389252"/>
                  <a:pt x="202676" y="368966"/>
                </a:cubicBezTo>
                <a:cubicBezTo>
                  <a:pt x="200866" y="358108"/>
                  <a:pt x="199051" y="338146"/>
                  <a:pt x="193250" y="326545"/>
                </a:cubicBezTo>
                <a:cubicBezTo>
                  <a:pt x="187923" y="315891"/>
                  <a:pt x="170169" y="295771"/>
                  <a:pt x="164969" y="288838"/>
                </a:cubicBezTo>
                <a:cubicBezTo>
                  <a:pt x="161570" y="284306"/>
                  <a:pt x="158684" y="279411"/>
                  <a:pt x="155542" y="274698"/>
                </a:cubicBezTo>
                <a:cubicBezTo>
                  <a:pt x="150829" y="255844"/>
                  <a:pt x="140190" y="237533"/>
                  <a:pt x="141402" y="218137"/>
                </a:cubicBezTo>
                <a:cubicBezTo>
                  <a:pt x="146712" y="133185"/>
                  <a:pt x="141976" y="167567"/>
                  <a:pt x="150829" y="114442"/>
                </a:cubicBezTo>
                <a:cubicBezTo>
                  <a:pt x="149049" y="85958"/>
                  <a:pt x="156440" y="46507"/>
                  <a:pt x="136689" y="20174"/>
                </a:cubicBezTo>
                <a:cubicBezTo>
                  <a:pt x="131356" y="13064"/>
                  <a:pt x="126267" y="4131"/>
                  <a:pt x="117835" y="1321"/>
                </a:cubicBezTo>
                <a:cubicBezTo>
                  <a:pt x="110235" y="-1212"/>
                  <a:pt x="82484" y="536"/>
                  <a:pt x="70701" y="1321"/>
                </a:cubicBezTo>
                <a:close/>
              </a:path>
            </a:pathLst>
          </a:custGeom>
          <a:noFill/>
          <a:ln>
            <a:solidFill>
              <a:schemeClr val="accent5">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 name="Freeform: Shape 6">
            <a:extLst>
              <a:ext uri="{FF2B5EF4-FFF2-40B4-BE49-F238E27FC236}">
                <a16:creationId xmlns:a16="http://schemas.microsoft.com/office/drawing/2014/main" id="{7A4B1664-1D57-57FD-2561-584D7D2156BE}"/>
              </a:ext>
            </a:extLst>
          </p:cNvPr>
          <p:cNvSpPr/>
          <p:nvPr/>
        </p:nvSpPr>
        <p:spPr>
          <a:xfrm>
            <a:off x="6886257" y="3756581"/>
            <a:ext cx="713931" cy="896355"/>
          </a:xfrm>
          <a:custGeom>
            <a:avLst/>
            <a:gdLst>
              <a:gd name="connsiteX0" fmla="*/ 240407 w 713931"/>
              <a:gd name="connsiteY0" fmla="*/ 329939 h 896355"/>
              <a:gd name="connsiteX1" fmla="*/ 216840 w 713931"/>
              <a:gd name="connsiteY1" fmla="*/ 344079 h 896355"/>
              <a:gd name="connsiteX2" fmla="*/ 197986 w 713931"/>
              <a:gd name="connsiteY2" fmla="*/ 348792 h 896355"/>
              <a:gd name="connsiteX3" fmla="*/ 174419 w 713931"/>
              <a:gd name="connsiteY3" fmla="*/ 353506 h 896355"/>
              <a:gd name="connsiteX4" fmla="*/ 117858 w 713931"/>
              <a:gd name="connsiteY4" fmla="*/ 362932 h 896355"/>
              <a:gd name="connsiteX5" fmla="*/ 84865 w 713931"/>
              <a:gd name="connsiteY5" fmla="*/ 372359 h 896355"/>
              <a:gd name="connsiteX6" fmla="*/ 66011 w 713931"/>
              <a:gd name="connsiteY6" fmla="*/ 377073 h 896355"/>
              <a:gd name="connsiteX7" fmla="*/ 28304 w 713931"/>
              <a:gd name="connsiteY7" fmla="*/ 410066 h 896355"/>
              <a:gd name="connsiteX8" fmla="*/ 9450 w 713931"/>
              <a:gd name="connsiteY8" fmla="*/ 438347 h 896355"/>
              <a:gd name="connsiteX9" fmla="*/ 23 w 713931"/>
              <a:gd name="connsiteY9" fmla="*/ 471341 h 896355"/>
              <a:gd name="connsiteX10" fmla="*/ 28304 w 713931"/>
              <a:gd name="connsiteY10" fmla="*/ 546755 h 896355"/>
              <a:gd name="connsiteX11" fmla="*/ 47157 w 713931"/>
              <a:gd name="connsiteY11" fmla="*/ 551468 h 896355"/>
              <a:gd name="connsiteX12" fmla="*/ 183846 w 713931"/>
              <a:gd name="connsiteY12" fmla="*/ 546755 h 896355"/>
              <a:gd name="connsiteX13" fmla="*/ 287541 w 713931"/>
              <a:gd name="connsiteY13" fmla="*/ 542042 h 896355"/>
              <a:gd name="connsiteX14" fmla="*/ 339388 w 713931"/>
              <a:gd name="connsiteY14" fmla="*/ 546755 h 896355"/>
              <a:gd name="connsiteX15" fmla="*/ 391236 w 713931"/>
              <a:gd name="connsiteY15" fmla="*/ 556182 h 896355"/>
              <a:gd name="connsiteX16" fmla="*/ 419516 w 713931"/>
              <a:gd name="connsiteY16" fmla="*/ 579749 h 896355"/>
              <a:gd name="connsiteX17" fmla="*/ 452510 w 713931"/>
              <a:gd name="connsiteY17" fmla="*/ 608029 h 896355"/>
              <a:gd name="connsiteX18" fmla="*/ 476077 w 713931"/>
              <a:gd name="connsiteY18" fmla="*/ 659877 h 896355"/>
              <a:gd name="connsiteX19" fmla="*/ 480790 w 713931"/>
              <a:gd name="connsiteY19" fmla="*/ 758858 h 896355"/>
              <a:gd name="connsiteX20" fmla="*/ 490217 w 713931"/>
              <a:gd name="connsiteY20" fmla="*/ 829559 h 896355"/>
              <a:gd name="connsiteX21" fmla="*/ 494931 w 713931"/>
              <a:gd name="connsiteY21" fmla="*/ 843699 h 896355"/>
              <a:gd name="connsiteX22" fmla="*/ 504357 w 713931"/>
              <a:gd name="connsiteY22" fmla="*/ 862553 h 896355"/>
              <a:gd name="connsiteX23" fmla="*/ 532638 w 713931"/>
              <a:gd name="connsiteY23" fmla="*/ 890833 h 896355"/>
              <a:gd name="connsiteX24" fmla="*/ 688180 w 713931"/>
              <a:gd name="connsiteY24" fmla="*/ 871980 h 896355"/>
              <a:gd name="connsiteX25" fmla="*/ 702320 w 713931"/>
              <a:gd name="connsiteY25" fmla="*/ 848413 h 896355"/>
              <a:gd name="connsiteX26" fmla="*/ 707034 w 713931"/>
              <a:gd name="connsiteY26" fmla="*/ 725864 h 896355"/>
              <a:gd name="connsiteX27" fmla="*/ 692894 w 713931"/>
              <a:gd name="connsiteY27" fmla="*/ 702297 h 896355"/>
              <a:gd name="connsiteX28" fmla="*/ 669327 w 713931"/>
              <a:gd name="connsiteY28" fmla="*/ 650450 h 896355"/>
              <a:gd name="connsiteX29" fmla="*/ 650473 w 713931"/>
              <a:gd name="connsiteY29" fmla="*/ 631596 h 896355"/>
              <a:gd name="connsiteX30" fmla="*/ 636333 w 713931"/>
              <a:gd name="connsiteY30" fmla="*/ 603316 h 896355"/>
              <a:gd name="connsiteX31" fmla="*/ 608052 w 713931"/>
              <a:gd name="connsiteY31" fmla="*/ 556182 h 896355"/>
              <a:gd name="connsiteX32" fmla="*/ 612766 w 713931"/>
              <a:gd name="connsiteY32" fmla="*/ 438347 h 896355"/>
              <a:gd name="connsiteX33" fmla="*/ 617479 w 713931"/>
              <a:gd name="connsiteY33" fmla="*/ 414780 h 896355"/>
              <a:gd name="connsiteX34" fmla="*/ 612766 w 713931"/>
              <a:gd name="connsiteY34" fmla="*/ 292231 h 896355"/>
              <a:gd name="connsiteX35" fmla="*/ 593912 w 713931"/>
              <a:gd name="connsiteY35" fmla="*/ 240384 h 896355"/>
              <a:gd name="connsiteX36" fmla="*/ 570345 w 713931"/>
              <a:gd name="connsiteY36" fmla="*/ 174396 h 896355"/>
              <a:gd name="connsiteX37" fmla="*/ 560918 w 713931"/>
              <a:gd name="connsiteY37" fmla="*/ 141403 h 896355"/>
              <a:gd name="connsiteX38" fmla="*/ 542065 w 713931"/>
              <a:gd name="connsiteY38" fmla="*/ 113122 h 896355"/>
              <a:gd name="connsiteX39" fmla="*/ 527924 w 713931"/>
              <a:gd name="connsiteY39" fmla="*/ 70701 h 896355"/>
              <a:gd name="connsiteX40" fmla="*/ 523211 w 713931"/>
              <a:gd name="connsiteY40" fmla="*/ 47134 h 896355"/>
              <a:gd name="connsiteX41" fmla="*/ 480790 w 713931"/>
              <a:gd name="connsiteY41" fmla="*/ 0 h 896355"/>
              <a:gd name="connsiteX42" fmla="*/ 447797 w 713931"/>
              <a:gd name="connsiteY42" fmla="*/ 4714 h 896355"/>
              <a:gd name="connsiteX43" fmla="*/ 433656 w 713931"/>
              <a:gd name="connsiteY43" fmla="*/ 14141 h 896355"/>
              <a:gd name="connsiteX44" fmla="*/ 410089 w 713931"/>
              <a:gd name="connsiteY44" fmla="*/ 56561 h 896355"/>
              <a:gd name="connsiteX45" fmla="*/ 405376 w 713931"/>
              <a:gd name="connsiteY45" fmla="*/ 75415 h 896355"/>
              <a:gd name="connsiteX46" fmla="*/ 410089 w 713931"/>
              <a:gd name="connsiteY46" fmla="*/ 136689 h 896355"/>
              <a:gd name="connsiteX47" fmla="*/ 424230 w 713931"/>
              <a:gd name="connsiteY47" fmla="*/ 150829 h 896355"/>
              <a:gd name="connsiteX48" fmla="*/ 433656 w 713931"/>
              <a:gd name="connsiteY48" fmla="*/ 164970 h 896355"/>
              <a:gd name="connsiteX49" fmla="*/ 461937 w 713931"/>
              <a:gd name="connsiteY49" fmla="*/ 193250 h 896355"/>
              <a:gd name="connsiteX50" fmla="*/ 476077 w 713931"/>
              <a:gd name="connsiteY50" fmla="*/ 207390 h 896355"/>
              <a:gd name="connsiteX51" fmla="*/ 499644 w 713931"/>
              <a:gd name="connsiteY51" fmla="*/ 249811 h 896355"/>
              <a:gd name="connsiteX52" fmla="*/ 518498 w 713931"/>
              <a:gd name="connsiteY52" fmla="*/ 278091 h 896355"/>
              <a:gd name="connsiteX53" fmla="*/ 527924 w 713931"/>
              <a:gd name="connsiteY53" fmla="*/ 306372 h 896355"/>
              <a:gd name="connsiteX54" fmla="*/ 532638 w 713931"/>
              <a:gd name="connsiteY54" fmla="*/ 320512 h 896355"/>
              <a:gd name="connsiteX55" fmla="*/ 542065 w 713931"/>
              <a:gd name="connsiteY55" fmla="*/ 391213 h 896355"/>
              <a:gd name="connsiteX56" fmla="*/ 546778 w 713931"/>
              <a:gd name="connsiteY56" fmla="*/ 452487 h 896355"/>
              <a:gd name="connsiteX57" fmla="*/ 551491 w 713931"/>
              <a:gd name="connsiteY57" fmla="*/ 466627 h 896355"/>
              <a:gd name="connsiteX58" fmla="*/ 556205 w 713931"/>
              <a:gd name="connsiteY58" fmla="*/ 490194 h 896355"/>
              <a:gd name="connsiteX59" fmla="*/ 494931 w 713931"/>
              <a:gd name="connsiteY59" fmla="*/ 513761 h 896355"/>
              <a:gd name="connsiteX60" fmla="*/ 476077 w 713931"/>
              <a:gd name="connsiteY60" fmla="*/ 504334 h 896355"/>
              <a:gd name="connsiteX61" fmla="*/ 424230 w 713931"/>
              <a:gd name="connsiteY61" fmla="*/ 476054 h 896355"/>
              <a:gd name="connsiteX62" fmla="*/ 391236 w 713931"/>
              <a:gd name="connsiteY62" fmla="*/ 452487 h 896355"/>
              <a:gd name="connsiteX63" fmla="*/ 329962 w 713931"/>
              <a:gd name="connsiteY63" fmla="*/ 433633 h 896355"/>
              <a:gd name="connsiteX64" fmla="*/ 287541 w 713931"/>
              <a:gd name="connsiteY64" fmla="*/ 428920 h 896355"/>
              <a:gd name="connsiteX65" fmla="*/ 263974 w 713931"/>
              <a:gd name="connsiteY65" fmla="*/ 405353 h 896355"/>
              <a:gd name="connsiteX66" fmla="*/ 259261 w 713931"/>
              <a:gd name="connsiteY66" fmla="*/ 386499 h 896355"/>
              <a:gd name="connsiteX67" fmla="*/ 249834 w 713931"/>
              <a:gd name="connsiteY67" fmla="*/ 372359 h 896355"/>
              <a:gd name="connsiteX68" fmla="*/ 245120 w 713931"/>
              <a:gd name="connsiteY68" fmla="*/ 358219 h 896355"/>
              <a:gd name="connsiteX69" fmla="*/ 240407 w 713931"/>
              <a:gd name="connsiteY69" fmla="*/ 329939 h 89635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Lst>
            <a:rect l="l" t="t" r="r" b="b"/>
            <a:pathLst>
              <a:path w="713931" h="896355">
                <a:moveTo>
                  <a:pt x="240407" y="329939"/>
                </a:moveTo>
                <a:cubicBezTo>
                  <a:pt x="235694" y="327582"/>
                  <a:pt x="225212" y="340358"/>
                  <a:pt x="216840" y="344079"/>
                </a:cubicBezTo>
                <a:cubicBezTo>
                  <a:pt x="210920" y="346710"/>
                  <a:pt x="204310" y="347387"/>
                  <a:pt x="197986" y="348792"/>
                </a:cubicBezTo>
                <a:cubicBezTo>
                  <a:pt x="190165" y="350530"/>
                  <a:pt x="182308" y="352114"/>
                  <a:pt x="174419" y="353506"/>
                </a:cubicBezTo>
                <a:cubicBezTo>
                  <a:pt x="155596" y="356828"/>
                  <a:pt x="136401" y="358296"/>
                  <a:pt x="117858" y="362932"/>
                </a:cubicBezTo>
                <a:cubicBezTo>
                  <a:pt x="58906" y="377672"/>
                  <a:pt x="132209" y="358832"/>
                  <a:pt x="84865" y="372359"/>
                </a:cubicBezTo>
                <a:cubicBezTo>
                  <a:pt x="78636" y="374139"/>
                  <a:pt x="72296" y="375502"/>
                  <a:pt x="66011" y="377073"/>
                </a:cubicBezTo>
                <a:cubicBezTo>
                  <a:pt x="56107" y="384996"/>
                  <a:pt x="37056" y="398813"/>
                  <a:pt x="28304" y="410066"/>
                </a:cubicBezTo>
                <a:cubicBezTo>
                  <a:pt x="21348" y="419009"/>
                  <a:pt x="9450" y="438347"/>
                  <a:pt x="9450" y="438347"/>
                </a:cubicBezTo>
                <a:cubicBezTo>
                  <a:pt x="7623" y="443830"/>
                  <a:pt x="-491" y="466969"/>
                  <a:pt x="23" y="471341"/>
                </a:cubicBezTo>
                <a:cubicBezTo>
                  <a:pt x="2520" y="492566"/>
                  <a:pt x="3521" y="532594"/>
                  <a:pt x="28304" y="546755"/>
                </a:cubicBezTo>
                <a:cubicBezTo>
                  <a:pt x="33928" y="549969"/>
                  <a:pt x="40873" y="549897"/>
                  <a:pt x="47157" y="551468"/>
                </a:cubicBezTo>
                <a:lnTo>
                  <a:pt x="183846" y="546755"/>
                </a:lnTo>
                <a:cubicBezTo>
                  <a:pt x="218420" y="545399"/>
                  <a:pt x="252940" y="542042"/>
                  <a:pt x="287541" y="542042"/>
                </a:cubicBezTo>
                <a:cubicBezTo>
                  <a:pt x="304895" y="542042"/>
                  <a:pt x="322141" y="544839"/>
                  <a:pt x="339388" y="546755"/>
                </a:cubicBezTo>
                <a:cubicBezTo>
                  <a:pt x="369791" y="550133"/>
                  <a:pt x="366854" y="550086"/>
                  <a:pt x="391236" y="556182"/>
                </a:cubicBezTo>
                <a:cubicBezTo>
                  <a:pt x="426343" y="579588"/>
                  <a:pt x="383225" y="549506"/>
                  <a:pt x="419516" y="579749"/>
                </a:cubicBezTo>
                <a:cubicBezTo>
                  <a:pt x="439781" y="596637"/>
                  <a:pt x="431643" y="581200"/>
                  <a:pt x="452510" y="608029"/>
                </a:cubicBezTo>
                <a:cubicBezTo>
                  <a:pt x="467484" y="627280"/>
                  <a:pt x="468394" y="636828"/>
                  <a:pt x="476077" y="659877"/>
                </a:cubicBezTo>
                <a:cubicBezTo>
                  <a:pt x="477648" y="692871"/>
                  <a:pt x="478730" y="725891"/>
                  <a:pt x="480790" y="758858"/>
                </a:cubicBezTo>
                <a:cubicBezTo>
                  <a:pt x="483013" y="794427"/>
                  <a:pt x="482444" y="802355"/>
                  <a:pt x="490217" y="829559"/>
                </a:cubicBezTo>
                <a:cubicBezTo>
                  <a:pt x="491582" y="834336"/>
                  <a:pt x="492974" y="839132"/>
                  <a:pt x="494931" y="843699"/>
                </a:cubicBezTo>
                <a:cubicBezTo>
                  <a:pt x="497699" y="850157"/>
                  <a:pt x="499968" y="857066"/>
                  <a:pt x="504357" y="862553"/>
                </a:cubicBezTo>
                <a:cubicBezTo>
                  <a:pt x="512685" y="872963"/>
                  <a:pt x="523211" y="881406"/>
                  <a:pt x="532638" y="890833"/>
                </a:cubicBezTo>
                <a:cubicBezTo>
                  <a:pt x="563372" y="889773"/>
                  <a:pt x="652465" y="912798"/>
                  <a:pt x="688180" y="871980"/>
                </a:cubicBezTo>
                <a:cubicBezTo>
                  <a:pt x="694213" y="865085"/>
                  <a:pt x="697607" y="856269"/>
                  <a:pt x="702320" y="848413"/>
                </a:cubicBezTo>
                <a:cubicBezTo>
                  <a:pt x="714087" y="795462"/>
                  <a:pt x="718996" y="791658"/>
                  <a:pt x="707034" y="725864"/>
                </a:cubicBezTo>
                <a:cubicBezTo>
                  <a:pt x="705395" y="716851"/>
                  <a:pt x="696685" y="710637"/>
                  <a:pt x="692894" y="702297"/>
                </a:cubicBezTo>
                <a:cubicBezTo>
                  <a:pt x="678489" y="670606"/>
                  <a:pt x="690498" y="677670"/>
                  <a:pt x="669327" y="650450"/>
                </a:cubicBezTo>
                <a:cubicBezTo>
                  <a:pt x="663870" y="643434"/>
                  <a:pt x="655570" y="638877"/>
                  <a:pt x="650473" y="631596"/>
                </a:cubicBezTo>
                <a:cubicBezTo>
                  <a:pt x="644429" y="622962"/>
                  <a:pt x="641991" y="612208"/>
                  <a:pt x="636333" y="603316"/>
                </a:cubicBezTo>
                <a:cubicBezTo>
                  <a:pt x="603837" y="552252"/>
                  <a:pt x="628243" y="606659"/>
                  <a:pt x="608052" y="556182"/>
                </a:cubicBezTo>
                <a:cubicBezTo>
                  <a:pt x="609623" y="516904"/>
                  <a:pt x="610151" y="477570"/>
                  <a:pt x="612766" y="438347"/>
                </a:cubicBezTo>
                <a:cubicBezTo>
                  <a:pt x="613299" y="430354"/>
                  <a:pt x="617479" y="422791"/>
                  <a:pt x="617479" y="414780"/>
                </a:cubicBezTo>
                <a:cubicBezTo>
                  <a:pt x="617479" y="373900"/>
                  <a:pt x="615398" y="333026"/>
                  <a:pt x="612766" y="292231"/>
                </a:cubicBezTo>
                <a:cubicBezTo>
                  <a:pt x="611136" y="266968"/>
                  <a:pt x="604858" y="264465"/>
                  <a:pt x="593912" y="240384"/>
                </a:cubicBezTo>
                <a:cubicBezTo>
                  <a:pt x="586072" y="223136"/>
                  <a:pt x="574612" y="189331"/>
                  <a:pt x="570345" y="174396"/>
                </a:cubicBezTo>
                <a:cubicBezTo>
                  <a:pt x="567203" y="163398"/>
                  <a:pt x="565711" y="151788"/>
                  <a:pt x="560918" y="141403"/>
                </a:cubicBezTo>
                <a:cubicBezTo>
                  <a:pt x="556170" y="131116"/>
                  <a:pt x="546856" y="123389"/>
                  <a:pt x="542065" y="113122"/>
                </a:cubicBezTo>
                <a:cubicBezTo>
                  <a:pt x="535762" y="99615"/>
                  <a:pt x="532019" y="85033"/>
                  <a:pt x="527924" y="70701"/>
                </a:cubicBezTo>
                <a:cubicBezTo>
                  <a:pt x="525723" y="62998"/>
                  <a:pt x="527009" y="54188"/>
                  <a:pt x="523211" y="47134"/>
                </a:cubicBezTo>
                <a:cubicBezTo>
                  <a:pt x="505471" y="14187"/>
                  <a:pt x="502978" y="14791"/>
                  <a:pt x="480790" y="0"/>
                </a:cubicBezTo>
                <a:cubicBezTo>
                  <a:pt x="469792" y="1571"/>
                  <a:pt x="458438" y="1522"/>
                  <a:pt x="447797" y="4714"/>
                </a:cubicBezTo>
                <a:cubicBezTo>
                  <a:pt x="442371" y="6342"/>
                  <a:pt x="437386" y="9878"/>
                  <a:pt x="433656" y="14141"/>
                </a:cubicBezTo>
                <a:cubicBezTo>
                  <a:pt x="419338" y="30504"/>
                  <a:pt x="415189" y="38712"/>
                  <a:pt x="410089" y="56561"/>
                </a:cubicBezTo>
                <a:cubicBezTo>
                  <a:pt x="408309" y="62790"/>
                  <a:pt x="406947" y="69130"/>
                  <a:pt x="405376" y="75415"/>
                </a:cubicBezTo>
                <a:cubicBezTo>
                  <a:pt x="406947" y="95840"/>
                  <a:pt x="405121" y="116816"/>
                  <a:pt x="410089" y="136689"/>
                </a:cubicBezTo>
                <a:cubicBezTo>
                  <a:pt x="411706" y="143156"/>
                  <a:pt x="419963" y="145708"/>
                  <a:pt x="424230" y="150829"/>
                </a:cubicBezTo>
                <a:cubicBezTo>
                  <a:pt x="427857" y="155181"/>
                  <a:pt x="429892" y="160736"/>
                  <a:pt x="433656" y="164970"/>
                </a:cubicBezTo>
                <a:cubicBezTo>
                  <a:pt x="442513" y="174934"/>
                  <a:pt x="452510" y="183823"/>
                  <a:pt x="461937" y="193250"/>
                </a:cubicBezTo>
                <a:cubicBezTo>
                  <a:pt x="466650" y="197963"/>
                  <a:pt x="472379" y="201844"/>
                  <a:pt x="476077" y="207390"/>
                </a:cubicBezTo>
                <a:cubicBezTo>
                  <a:pt x="503300" y="248222"/>
                  <a:pt x="460739" y="183117"/>
                  <a:pt x="499644" y="249811"/>
                </a:cubicBezTo>
                <a:cubicBezTo>
                  <a:pt x="505353" y="259597"/>
                  <a:pt x="518498" y="278091"/>
                  <a:pt x="518498" y="278091"/>
                </a:cubicBezTo>
                <a:lnTo>
                  <a:pt x="527924" y="306372"/>
                </a:lnTo>
                <a:lnTo>
                  <a:pt x="532638" y="320512"/>
                </a:lnTo>
                <a:cubicBezTo>
                  <a:pt x="535323" y="339312"/>
                  <a:pt x="540327" y="372963"/>
                  <a:pt x="542065" y="391213"/>
                </a:cubicBezTo>
                <a:cubicBezTo>
                  <a:pt x="544007" y="411606"/>
                  <a:pt x="544237" y="432160"/>
                  <a:pt x="546778" y="452487"/>
                </a:cubicBezTo>
                <a:cubicBezTo>
                  <a:pt x="547394" y="457417"/>
                  <a:pt x="550286" y="461807"/>
                  <a:pt x="551491" y="466627"/>
                </a:cubicBezTo>
                <a:cubicBezTo>
                  <a:pt x="553434" y="474399"/>
                  <a:pt x="554634" y="482338"/>
                  <a:pt x="556205" y="490194"/>
                </a:cubicBezTo>
                <a:cubicBezTo>
                  <a:pt x="548943" y="533764"/>
                  <a:pt x="559902" y="525944"/>
                  <a:pt x="494931" y="513761"/>
                </a:cubicBezTo>
                <a:cubicBezTo>
                  <a:pt x="488025" y="512466"/>
                  <a:pt x="482498" y="507188"/>
                  <a:pt x="476077" y="504334"/>
                </a:cubicBezTo>
                <a:cubicBezTo>
                  <a:pt x="439499" y="488078"/>
                  <a:pt x="462886" y="503113"/>
                  <a:pt x="424230" y="476054"/>
                </a:cubicBezTo>
                <a:cubicBezTo>
                  <a:pt x="422022" y="474508"/>
                  <a:pt x="396641" y="454739"/>
                  <a:pt x="391236" y="452487"/>
                </a:cubicBezTo>
                <a:cubicBezTo>
                  <a:pt x="386125" y="450357"/>
                  <a:pt x="344389" y="435853"/>
                  <a:pt x="329962" y="433633"/>
                </a:cubicBezTo>
                <a:cubicBezTo>
                  <a:pt x="315900" y="431470"/>
                  <a:pt x="301681" y="430491"/>
                  <a:pt x="287541" y="428920"/>
                </a:cubicBezTo>
                <a:cubicBezTo>
                  <a:pt x="274973" y="420541"/>
                  <a:pt x="270258" y="420016"/>
                  <a:pt x="263974" y="405353"/>
                </a:cubicBezTo>
                <a:cubicBezTo>
                  <a:pt x="261422" y="399399"/>
                  <a:pt x="261813" y="392453"/>
                  <a:pt x="259261" y="386499"/>
                </a:cubicBezTo>
                <a:cubicBezTo>
                  <a:pt x="257030" y="381292"/>
                  <a:pt x="252368" y="377426"/>
                  <a:pt x="249834" y="372359"/>
                </a:cubicBezTo>
                <a:cubicBezTo>
                  <a:pt x="247612" y="367915"/>
                  <a:pt x="247077" y="362786"/>
                  <a:pt x="245120" y="358219"/>
                </a:cubicBezTo>
                <a:cubicBezTo>
                  <a:pt x="237303" y="339980"/>
                  <a:pt x="245120" y="332296"/>
                  <a:pt x="240407" y="329939"/>
                </a:cubicBezTo>
                <a:close/>
              </a:path>
            </a:pathLst>
          </a:cu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Tree>
    <p:extLst>
      <p:ext uri="{BB962C8B-B14F-4D97-AF65-F5344CB8AC3E}">
        <p14:creationId xmlns:p14="http://schemas.microsoft.com/office/powerpoint/2010/main" val="299208202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75AF7AF-97EA-4A6C-9C54-E7486EC56404}"/>
              </a:ext>
            </a:extLst>
          </p:cNvPr>
          <p:cNvSpPr>
            <a:spLocks noGrp="1"/>
          </p:cNvSpPr>
          <p:nvPr>
            <p:ph type="title"/>
          </p:nvPr>
        </p:nvSpPr>
        <p:spPr/>
        <p:txBody>
          <a:bodyPr/>
          <a:lstStyle/>
          <a:p>
            <a:r>
              <a:rPr lang="en-GB" dirty="0"/>
              <a:t>Supp Fig 3. </a:t>
            </a:r>
          </a:p>
        </p:txBody>
      </p:sp>
      <p:pic>
        <p:nvPicPr>
          <p:cNvPr id="4" name="Content Placeholder 3">
            <a:extLst>
              <a:ext uri="{FF2B5EF4-FFF2-40B4-BE49-F238E27FC236}">
                <a16:creationId xmlns:a16="http://schemas.microsoft.com/office/drawing/2014/main" id="{9D2E5399-78A6-45AE-A7C6-05BCBBF9BC28}"/>
              </a:ext>
            </a:extLst>
          </p:cNvPr>
          <p:cNvPicPr>
            <a:picLocks noGrp="1" noChangeAspect="1"/>
          </p:cNvPicPr>
          <p:nvPr>
            <p:ph idx="1"/>
          </p:nvPr>
        </p:nvPicPr>
        <p:blipFill>
          <a:blip r:embed="rId3"/>
          <a:stretch>
            <a:fillRect/>
          </a:stretch>
        </p:blipFill>
        <p:spPr>
          <a:xfrm>
            <a:off x="1857254" y="1825625"/>
            <a:ext cx="8477492" cy="4351338"/>
          </a:xfrm>
          <a:prstGeom prst="rect">
            <a:avLst/>
          </a:prstGeom>
        </p:spPr>
      </p:pic>
    </p:spTree>
    <p:extLst>
      <p:ext uri="{BB962C8B-B14F-4D97-AF65-F5344CB8AC3E}">
        <p14:creationId xmlns:p14="http://schemas.microsoft.com/office/powerpoint/2010/main" val="83306521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5E7824-3C79-05C8-4E8D-241A8764CBE7}"/>
              </a:ext>
            </a:extLst>
          </p:cNvPr>
          <p:cNvSpPr>
            <a:spLocks noGrp="1"/>
          </p:cNvSpPr>
          <p:nvPr>
            <p:ph type="title"/>
          </p:nvPr>
        </p:nvSpPr>
        <p:spPr/>
        <p:txBody>
          <a:bodyPr/>
          <a:lstStyle/>
          <a:p>
            <a:r>
              <a:rPr lang="en-GB" dirty="0"/>
              <a:t>Supp Fig 4. </a:t>
            </a:r>
          </a:p>
        </p:txBody>
      </p:sp>
      <p:pic>
        <p:nvPicPr>
          <p:cNvPr id="4" name="Content Placeholder 12">
            <a:extLst>
              <a:ext uri="{FF2B5EF4-FFF2-40B4-BE49-F238E27FC236}">
                <a16:creationId xmlns:a16="http://schemas.microsoft.com/office/drawing/2014/main" id="{0BFEDA49-F55F-5627-4C58-0A1C0F4CFC89}"/>
              </a:ext>
            </a:extLst>
          </p:cNvPr>
          <p:cNvPicPr>
            <a:picLocks noGrp="1" noChangeAspect="1"/>
          </p:cNvPicPr>
          <p:nvPr>
            <p:ph idx="1"/>
          </p:nvPr>
        </p:nvPicPr>
        <p:blipFill rotWithShape="1">
          <a:blip r:embed="rId3"/>
          <a:srcRect l="-431" t="-4" r="-1155" b="5"/>
          <a:stretch/>
        </p:blipFill>
        <p:spPr>
          <a:xfrm>
            <a:off x="2803803" y="1825625"/>
            <a:ext cx="6584394" cy="4351338"/>
          </a:xfrm>
          <a:prstGeom prst="rect">
            <a:avLst/>
          </a:prstGeom>
        </p:spPr>
      </p:pic>
    </p:spTree>
    <p:extLst>
      <p:ext uri="{BB962C8B-B14F-4D97-AF65-F5344CB8AC3E}">
        <p14:creationId xmlns:p14="http://schemas.microsoft.com/office/powerpoint/2010/main" val="377170926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BB34FDC-48FE-4C84-BFA5-62687D8D4600}"/>
              </a:ext>
            </a:extLst>
          </p:cNvPr>
          <p:cNvSpPr>
            <a:spLocks noGrp="1"/>
          </p:cNvSpPr>
          <p:nvPr>
            <p:ph type="title"/>
          </p:nvPr>
        </p:nvSpPr>
        <p:spPr/>
        <p:txBody>
          <a:bodyPr/>
          <a:lstStyle/>
          <a:p>
            <a:r>
              <a:rPr lang="en-GB" dirty="0"/>
              <a:t>Supp Fig 5. </a:t>
            </a:r>
          </a:p>
        </p:txBody>
      </p:sp>
      <p:pic>
        <p:nvPicPr>
          <p:cNvPr id="7" name="Picture 6">
            <a:extLst>
              <a:ext uri="{FF2B5EF4-FFF2-40B4-BE49-F238E27FC236}">
                <a16:creationId xmlns:a16="http://schemas.microsoft.com/office/drawing/2014/main" id="{23B1529F-8D1A-FF77-874D-1DE86C924DDC}"/>
              </a:ext>
            </a:extLst>
          </p:cNvPr>
          <p:cNvPicPr>
            <a:picLocks noChangeAspect="1"/>
          </p:cNvPicPr>
          <p:nvPr/>
        </p:nvPicPr>
        <p:blipFill>
          <a:blip r:embed="rId3"/>
          <a:stretch>
            <a:fillRect/>
          </a:stretch>
        </p:blipFill>
        <p:spPr>
          <a:xfrm>
            <a:off x="838200" y="1825625"/>
            <a:ext cx="10724909" cy="4129088"/>
          </a:xfrm>
          <a:prstGeom prst="rect">
            <a:avLst/>
          </a:prstGeom>
        </p:spPr>
      </p:pic>
    </p:spTree>
    <p:extLst>
      <p:ext uri="{BB962C8B-B14F-4D97-AF65-F5344CB8AC3E}">
        <p14:creationId xmlns:p14="http://schemas.microsoft.com/office/powerpoint/2010/main" val="111940634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DE088FC-95BA-4A1C-8E49-C4D680E29ADB}"/>
              </a:ext>
            </a:extLst>
          </p:cNvPr>
          <p:cNvSpPr>
            <a:spLocks noGrp="1"/>
          </p:cNvSpPr>
          <p:nvPr>
            <p:ph type="title"/>
          </p:nvPr>
        </p:nvSpPr>
        <p:spPr/>
        <p:txBody>
          <a:bodyPr/>
          <a:lstStyle/>
          <a:p>
            <a:r>
              <a:rPr lang="en-GB" dirty="0"/>
              <a:t>Supp Fig 6.</a:t>
            </a:r>
          </a:p>
        </p:txBody>
      </p:sp>
      <p:pic>
        <p:nvPicPr>
          <p:cNvPr id="9" name="Picture 8">
            <a:extLst>
              <a:ext uri="{FF2B5EF4-FFF2-40B4-BE49-F238E27FC236}">
                <a16:creationId xmlns:a16="http://schemas.microsoft.com/office/drawing/2014/main" id="{621DA7A4-361E-4DE2-A7BB-A6C0069449AB}"/>
              </a:ext>
            </a:extLst>
          </p:cNvPr>
          <p:cNvPicPr>
            <a:picLocks noChangeAspect="1"/>
          </p:cNvPicPr>
          <p:nvPr/>
        </p:nvPicPr>
        <p:blipFill>
          <a:blip r:embed="rId3"/>
          <a:stretch>
            <a:fillRect/>
          </a:stretch>
        </p:blipFill>
        <p:spPr>
          <a:xfrm>
            <a:off x="1289785" y="1690688"/>
            <a:ext cx="9853061" cy="4960150"/>
          </a:xfrm>
          <a:prstGeom prst="rect">
            <a:avLst/>
          </a:prstGeom>
        </p:spPr>
      </p:pic>
      <p:sp>
        <p:nvSpPr>
          <p:cNvPr id="4" name="Rectangle: Rounded Corners 3">
            <a:extLst>
              <a:ext uri="{FF2B5EF4-FFF2-40B4-BE49-F238E27FC236}">
                <a16:creationId xmlns:a16="http://schemas.microsoft.com/office/drawing/2014/main" id="{7B357F47-0204-4F76-9BB4-CC5C235B8FB6}"/>
              </a:ext>
            </a:extLst>
          </p:cNvPr>
          <p:cNvSpPr/>
          <p:nvPr/>
        </p:nvSpPr>
        <p:spPr>
          <a:xfrm>
            <a:off x="2836506" y="2929812"/>
            <a:ext cx="335902" cy="270588"/>
          </a:xfrm>
          <a:prstGeom prst="roundRect">
            <a:avLst/>
          </a:prstGeom>
          <a:noFill/>
          <a:ln w="28575">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0" name="Rectangle: Rounded Corners 9">
            <a:extLst>
              <a:ext uri="{FF2B5EF4-FFF2-40B4-BE49-F238E27FC236}">
                <a16:creationId xmlns:a16="http://schemas.microsoft.com/office/drawing/2014/main" id="{3541B64C-818D-4903-BEE5-74569A6E5A25}"/>
              </a:ext>
            </a:extLst>
          </p:cNvPr>
          <p:cNvSpPr/>
          <p:nvPr/>
        </p:nvSpPr>
        <p:spPr>
          <a:xfrm>
            <a:off x="7290318" y="2880956"/>
            <a:ext cx="335902" cy="1112545"/>
          </a:xfrm>
          <a:prstGeom prst="roundRect">
            <a:avLst/>
          </a:prstGeom>
          <a:noFill/>
          <a:ln w="28575">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1" name="Rectangle: Rounded Corners 10">
            <a:extLst>
              <a:ext uri="{FF2B5EF4-FFF2-40B4-BE49-F238E27FC236}">
                <a16:creationId xmlns:a16="http://schemas.microsoft.com/office/drawing/2014/main" id="{34A67A90-9F82-4A04-9C8B-9A95575587CB}"/>
              </a:ext>
            </a:extLst>
          </p:cNvPr>
          <p:cNvSpPr/>
          <p:nvPr/>
        </p:nvSpPr>
        <p:spPr>
          <a:xfrm>
            <a:off x="2957804" y="5473958"/>
            <a:ext cx="824204" cy="684245"/>
          </a:xfrm>
          <a:prstGeom prst="roundRect">
            <a:avLst/>
          </a:prstGeom>
          <a:noFill/>
          <a:ln w="28575">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Tree>
    <p:extLst>
      <p:ext uri="{BB962C8B-B14F-4D97-AF65-F5344CB8AC3E}">
        <p14:creationId xmlns:p14="http://schemas.microsoft.com/office/powerpoint/2010/main" val="108274865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36634C8-230C-4C18-8F79-9C9E0A5D5E38}"/>
              </a:ext>
            </a:extLst>
          </p:cNvPr>
          <p:cNvSpPr>
            <a:spLocks noGrp="1"/>
          </p:cNvSpPr>
          <p:nvPr>
            <p:ph type="title"/>
          </p:nvPr>
        </p:nvSpPr>
        <p:spPr/>
        <p:txBody>
          <a:bodyPr/>
          <a:lstStyle/>
          <a:p>
            <a:r>
              <a:rPr lang="en-GB" dirty="0"/>
              <a:t>Supp Fig 7. </a:t>
            </a:r>
          </a:p>
        </p:txBody>
      </p:sp>
      <p:pic>
        <p:nvPicPr>
          <p:cNvPr id="7" name="Picture 6">
            <a:extLst>
              <a:ext uri="{FF2B5EF4-FFF2-40B4-BE49-F238E27FC236}">
                <a16:creationId xmlns:a16="http://schemas.microsoft.com/office/drawing/2014/main" id="{AB80F1DB-875A-43A5-ACF7-7A771FF98469}"/>
              </a:ext>
            </a:extLst>
          </p:cNvPr>
          <p:cNvPicPr>
            <a:picLocks noChangeAspect="1"/>
          </p:cNvPicPr>
          <p:nvPr/>
        </p:nvPicPr>
        <p:blipFill>
          <a:blip r:embed="rId3"/>
          <a:stretch>
            <a:fillRect/>
          </a:stretch>
        </p:blipFill>
        <p:spPr>
          <a:xfrm>
            <a:off x="2175309" y="1442607"/>
            <a:ext cx="8615735" cy="5415393"/>
          </a:xfrm>
          <a:prstGeom prst="rect">
            <a:avLst/>
          </a:prstGeom>
        </p:spPr>
      </p:pic>
    </p:spTree>
    <p:extLst>
      <p:ext uri="{BB962C8B-B14F-4D97-AF65-F5344CB8AC3E}">
        <p14:creationId xmlns:p14="http://schemas.microsoft.com/office/powerpoint/2010/main" val="138267638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87440DB-3D51-46E4-A3EA-87B8B70AFE7D}"/>
              </a:ext>
            </a:extLst>
          </p:cNvPr>
          <p:cNvSpPr>
            <a:spLocks noGrp="1"/>
          </p:cNvSpPr>
          <p:nvPr>
            <p:ph type="title"/>
          </p:nvPr>
        </p:nvSpPr>
        <p:spPr>
          <a:xfrm>
            <a:off x="395439" y="365125"/>
            <a:ext cx="2623372" cy="1325563"/>
          </a:xfrm>
        </p:spPr>
        <p:txBody>
          <a:bodyPr>
            <a:normAutofit/>
          </a:bodyPr>
          <a:lstStyle/>
          <a:p>
            <a:r>
              <a:rPr lang="en-GB" dirty="0"/>
              <a:t>Supp Fig 8.</a:t>
            </a:r>
          </a:p>
        </p:txBody>
      </p:sp>
      <p:pic>
        <p:nvPicPr>
          <p:cNvPr id="5" name="Content Placeholder 4">
            <a:extLst>
              <a:ext uri="{FF2B5EF4-FFF2-40B4-BE49-F238E27FC236}">
                <a16:creationId xmlns:a16="http://schemas.microsoft.com/office/drawing/2014/main" id="{138601E0-0B7D-460E-A9F2-1EE038E7DF28}"/>
              </a:ext>
            </a:extLst>
          </p:cNvPr>
          <p:cNvPicPr>
            <a:picLocks noGrp="1" noChangeAspect="1"/>
          </p:cNvPicPr>
          <p:nvPr>
            <p:ph idx="1"/>
          </p:nvPr>
        </p:nvPicPr>
        <p:blipFill>
          <a:blip r:embed="rId3"/>
          <a:stretch>
            <a:fillRect/>
          </a:stretch>
        </p:blipFill>
        <p:spPr>
          <a:xfrm>
            <a:off x="3461572" y="482451"/>
            <a:ext cx="8334989" cy="5893098"/>
          </a:xfrm>
        </p:spPr>
      </p:pic>
    </p:spTree>
    <p:extLst>
      <p:ext uri="{BB962C8B-B14F-4D97-AF65-F5344CB8AC3E}">
        <p14:creationId xmlns:p14="http://schemas.microsoft.com/office/powerpoint/2010/main" val="196808018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75</TotalTime>
  <Words>728</Words>
  <Application>Microsoft Office PowerPoint</Application>
  <PresentationFormat>Widescreen</PresentationFormat>
  <Paragraphs>31</Paragraphs>
  <Slides>11</Slides>
  <Notes>1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1</vt:i4>
      </vt:variant>
    </vt:vector>
  </HeadingPairs>
  <TitlesOfParts>
    <vt:vector size="15" baseType="lpstr">
      <vt:lpstr>Arial</vt:lpstr>
      <vt:lpstr>Calibri</vt:lpstr>
      <vt:lpstr>Calibri Light</vt:lpstr>
      <vt:lpstr>Office Theme</vt:lpstr>
      <vt:lpstr>Supplementary Figures</vt:lpstr>
      <vt:lpstr>Supp. Fig. 1.</vt:lpstr>
      <vt:lpstr>Supp. Fig. 2. </vt:lpstr>
      <vt:lpstr>Supp Fig 3. </vt:lpstr>
      <vt:lpstr>Supp Fig 4. </vt:lpstr>
      <vt:lpstr>Supp Fig 5. </vt:lpstr>
      <vt:lpstr>Supp Fig 6.</vt:lpstr>
      <vt:lpstr>Supp Fig 7. </vt:lpstr>
      <vt:lpstr>Supp Fig 8.</vt:lpstr>
      <vt:lpstr>Supp Fig 9.</vt:lpstr>
      <vt:lpstr>Supp Fig 10.</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Tables and Figures</dc:title>
  <dc:creator>Akshay Patel</dc:creator>
  <cp:lastModifiedBy>Akshay Patel (Immunology and Immunotherapy)</cp:lastModifiedBy>
  <cp:revision>13</cp:revision>
  <dcterms:created xsi:type="dcterms:W3CDTF">2023-01-16T17:09:36Z</dcterms:created>
  <dcterms:modified xsi:type="dcterms:W3CDTF">2023-05-10T15:25:47Z</dcterms:modified>
</cp:coreProperties>
</file>